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15" autoAdjust="0"/>
    <p:restoredTop sz="94660"/>
  </p:normalViewPr>
  <p:slideViewPr>
    <p:cSldViewPr snapToGrid="0">
      <p:cViewPr varScale="1">
        <p:scale>
          <a:sx n="89" d="100"/>
          <a:sy n="89" d="100"/>
        </p:scale>
        <p:origin x="120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659C8D-85E5-4E0A-9C88-0BC5A20D5B1E}" type="datetimeFigureOut">
              <a:rPr lang="it-IT" smtClean="0"/>
              <a:t>11/01/2019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12D1848-CB14-4D8F-8F62-6E44E6CB39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926536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BF034-B130-443A-AE46-CEC31E1A16DD}" type="datetimeFigureOut">
              <a:rPr lang="it-IT" smtClean="0"/>
              <a:t>11/01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F1AE2-B26A-4060-AFB6-1FACF5C4442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209499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BF034-B130-443A-AE46-CEC31E1A16DD}" type="datetimeFigureOut">
              <a:rPr lang="it-IT" smtClean="0"/>
              <a:t>11/01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F1AE2-B26A-4060-AFB6-1FACF5C4442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990772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BF034-B130-443A-AE46-CEC31E1A16DD}" type="datetimeFigureOut">
              <a:rPr lang="it-IT" smtClean="0"/>
              <a:t>11/01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F1AE2-B26A-4060-AFB6-1FACF5C4442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68284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BF034-B130-443A-AE46-CEC31E1A16DD}" type="datetimeFigureOut">
              <a:rPr lang="it-IT" smtClean="0"/>
              <a:t>11/01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F1AE2-B26A-4060-AFB6-1FACF5C4442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260878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BF034-B130-443A-AE46-CEC31E1A16DD}" type="datetimeFigureOut">
              <a:rPr lang="it-IT" smtClean="0"/>
              <a:t>11/01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F1AE2-B26A-4060-AFB6-1FACF5C4442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799570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BF034-B130-443A-AE46-CEC31E1A16DD}" type="datetimeFigureOut">
              <a:rPr lang="it-IT" smtClean="0"/>
              <a:t>11/01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F1AE2-B26A-4060-AFB6-1FACF5C4442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493075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BF034-B130-443A-AE46-CEC31E1A16DD}" type="datetimeFigureOut">
              <a:rPr lang="it-IT" smtClean="0"/>
              <a:t>11/01/2019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F1AE2-B26A-4060-AFB6-1FACF5C4442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96902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BF034-B130-443A-AE46-CEC31E1A16DD}" type="datetimeFigureOut">
              <a:rPr lang="it-IT" smtClean="0"/>
              <a:t>11/01/2019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F1AE2-B26A-4060-AFB6-1FACF5C4442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245437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BF034-B130-443A-AE46-CEC31E1A16DD}" type="datetimeFigureOut">
              <a:rPr lang="it-IT" smtClean="0"/>
              <a:t>11/01/2019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F1AE2-B26A-4060-AFB6-1FACF5C4442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981402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BF034-B130-443A-AE46-CEC31E1A16DD}" type="datetimeFigureOut">
              <a:rPr lang="it-IT" smtClean="0"/>
              <a:t>11/01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F1AE2-B26A-4060-AFB6-1FACF5C4442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396907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BF034-B130-443A-AE46-CEC31E1A16DD}" type="datetimeFigureOut">
              <a:rPr lang="it-IT" smtClean="0"/>
              <a:t>11/01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F1AE2-B26A-4060-AFB6-1FACF5C4442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728277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8BF034-B130-443A-AE46-CEC31E1A16DD}" type="datetimeFigureOut">
              <a:rPr lang="it-IT" smtClean="0"/>
              <a:t>11/01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9F1AE2-B26A-4060-AFB6-1FACF5C4442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43775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Relationship Id="rId9" Type="http://schemas.openxmlformats.org/officeDocument/2006/relationships/image" Target="../media/image24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4" Type="http://schemas.openxmlformats.org/officeDocument/2006/relationships/image" Target="../media/image27.png"/><Relationship Id="rId9" Type="http://schemas.openxmlformats.org/officeDocument/2006/relationships/image" Target="../media/image3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11213313" y="6488668"/>
            <a:ext cx="936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Figure 1</a:t>
            </a:r>
            <a:endParaRPr lang="it-IT" dirty="0"/>
          </a:p>
        </p:txBody>
      </p:sp>
      <p:grpSp>
        <p:nvGrpSpPr>
          <p:cNvPr id="60" name="Gruppo 59"/>
          <p:cNvGrpSpPr/>
          <p:nvPr/>
        </p:nvGrpSpPr>
        <p:grpSpPr>
          <a:xfrm>
            <a:off x="4602644" y="260302"/>
            <a:ext cx="6399091" cy="2277566"/>
            <a:chOff x="2599957" y="445251"/>
            <a:chExt cx="6399091" cy="2277566"/>
          </a:xfrm>
        </p:grpSpPr>
        <p:pic>
          <p:nvPicPr>
            <p:cNvPr id="61" name="Immagine 60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599957" y="1438574"/>
              <a:ext cx="4945451" cy="410901"/>
            </a:xfrm>
            <a:prstGeom prst="rect">
              <a:avLst/>
            </a:prstGeom>
            <a:ln>
              <a:noFill/>
            </a:ln>
          </p:spPr>
        </p:pic>
        <p:pic>
          <p:nvPicPr>
            <p:cNvPr id="62" name="Immagine 6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615067" y="958255"/>
              <a:ext cx="4945451" cy="410902"/>
            </a:xfrm>
            <a:prstGeom prst="rect">
              <a:avLst/>
            </a:prstGeom>
            <a:ln>
              <a:noFill/>
            </a:ln>
          </p:spPr>
        </p:pic>
        <p:sp>
          <p:nvSpPr>
            <p:cNvPr id="63" name="Rettangolo 62"/>
            <p:cNvSpPr/>
            <p:nvPr/>
          </p:nvSpPr>
          <p:spPr>
            <a:xfrm>
              <a:off x="7627447" y="970287"/>
              <a:ext cx="1371601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400" b="0" i="0" u="none" strike="noStrike" kern="0" cap="none" spc="0" normalizeH="0" baseline="0" noProof="0" dirty="0" err="1">
                  <a:ln>
                    <a:noFill/>
                  </a:ln>
                  <a:solidFill>
                    <a:srgbClr val="040503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pERK</a:t>
              </a:r>
              <a:r>
                <a:rPr kumimoji="0" lang="it-IT" sz="1400" b="0" i="0" u="none" strike="noStrike" kern="0" cap="none" spc="0" normalizeH="0" baseline="0" noProof="0" dirty="0">
                  <a:ln>
                    <a:noFill/>
                  </a:ln>
                  <a:solidFill>
                    <a:srgbClr val="040503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it-IT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srgbClr val="040503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(42 </a:t>
              </a:r>
              <a:r>
                <a:rPr kumimoji="0" lang="it-IT" sz="1400" b="0" i="0" u="none" strike="noStrike" kern="0" cap="none" spc="0" normalizeH="0" baseline="0" noProof="0" dirty="0" err="1" smtClean="0">
                  <a:ln>
                    <a:noFill/>
                  </a:ln>
                  <a:solidFill>
                    <a:srgbClr val="040503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r>
                <a:rPr kumimoji="0" lang="it-IT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srgbClr val="040503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r>
                <a:rPr kumimoji="0" lang="it-IT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kumimoji="0" lang="it-IT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CasellaDiTesto 63"/>
            <p:cNvSpPr txBox="1"/>
            <p:nvPr/>
          </p:nvSpPr>
          <p:spPr>
            <a:xfrm>
              <a:off x="7702200" y="1546862"/>
              <a:ext cx="1272784" cy="215444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l-GR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β</a:t>
              </a:r>
              <a:r>
                <a:rPr kumimoji="0" lang="it-IT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it-IT" sz="14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actin</a:t>
              </a:r>
              <a:r>
                <a:rPr kumimoji="0" lang="it-IT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srgbClr val="040503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(42 </a:t>
              </a:r>
              <a:r>
                <a:rPr kumimoji="0" lang="it-IT" sz="1400" b="0" i="0" u="none" strike="noStrike" kern="0" cap="none" spc="0" normalizeH="0" baseline="0" noProof="0" dirty="0" err="1" smtClean="0">
                  <a:ln>
                    <a:noFill/>
                  </a:ln>
                  <a:solidFill>
                    <a:srgbClr val="040503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r>
                <a:rPr kumimoji="0" lang="it-IT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srgbClr val="040503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r>
                <a:rPr kumimoji="0" lang="it-IT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kumimoji="0" lang="it-IT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CasellaDiTesto 64"/>
            <p:cNvSpPr txBox="1"/>
            <p:nvPr/>
          </p:nvSpPr>
          <p:spPr>
            <a:xfrm>
              <a:off x="4506940" y="445251"/>
              <a:ext cx="108529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1a</a:t>
              </a:r>
              <a:endParaRPr kumimoji="0" lang="it-IT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CasellaDiTesto 65"/>
            <p:cNvSpPr txBox="1"/>
            <p:nvPr/>
          </p:nvSpPr>
          <p:spPr>
            <a:xfrm rot="16200000">
              <a:off x="2583603" y="2074554"/>
              <a:ext cx="76853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Untreated</a:t>
              </a:r>
              <a:r>
                <a:rPr kumimoji="0" lang="it-IT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/>
              </a:r>
              <a:br>
                <a:rPr kumimoji="0" lang="it-IT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</a:br>
              <a:r>
                <a:rPr kumimoji="0" lang="it-IT" sz="10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ells</a:t>
              </a:r>
              <a:r>
                <a:rPr kumimoji="0" lang="it-IT" sz="10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 </a:t>
              </a:r>
              <a:endParaRPr kumimoji="0" lang="it-IT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Rettangolo 66"/>
            <p:cNvSpPr/>
            <p:nvPr/>
          </p:nvSpPr>
          <p:spPr>
            <a:xfrm rot="16200000">
              <a:off x="6894080" y="2112347"/>
              <a:ext cx="690237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b="0" i="0" u="none" strike="noStrike" kern="0" cap="none" spc="0" normalizeH="0" baseline="0" noProof="0" dirty="0" smtClean="0">
                  <a:ln>
                    <a:noFill/>
                  </a:ln>
                  <a:solidFill>
                    <a:srgbClr val="040503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rhIL-17A</a:t>
              </a:r>
              <a:r>
                <a:rPr kumimoji="0" lang="it-IT" sz="10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kumimoji="0" lang="it-IT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Rettangolo 67"/>
            <p:cNvSpPr/>
            <p:nvPr/>
          </p:nvSpPr>
          <p:spPr>
            <a:xfrm rot="16200000">
              <a:off x="3646114" y="2064410"/>
              <a:ext cx="748251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b="0" i="0" u="none" strike="noStrike" kern="0" cap="none" spc="0" normalizeH="0" baseline="0" noProof="0" dirty="0" smtClean="0">
                  <a:ln>
                    <a:noFill/>
                  </a:ln>
                  <a:solidFill>
                    <a:srgbClr val="040503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HMW-HA </a:t>
              </a: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b="0" i="0" u="none" strike="noStrike" kern="0" cap="none" spc="0" normalizeH="0" baseline="0" noProof="0" dirty="0" smtClean="0">
                  <a:ln>
                    <a:noFill/>
                  </a:ln>
                  <a:solidFill>
                    <a:srgbClr val="040503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rhIL-17A</a:t>
              </a:r>
              <a:r>
                <a:rPr kumimoji="0" lang="it-IT" sz="10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kumimoji="0" lang="it-IT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Rettangolo 68"/>
            <p:cNvSpPr/>
            <p:nvPr/>
          </p:nvSpPr>
          <p:spPr>
            <a:xfrm rot="16200000">
              <a:off x="4179659" y="2106523"/>
              <a:ext cx="832478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b="0" i="0" u="none" strike="noStrike" kern="0" cap="none" spc="0" normalizeH="0" baseline="0" noProof="0" dirty="0" smtClean="0">
                  <a:ln>
                    <a:noFill/>
                  </a:ln>
                  <a:solidFill>
                    <a:srgbClr val="040503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MMW-HA </a:t>
              </a: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b="0" i="0" u="none" strike="noStrike" kern="0" cap="none" spc="0" normalizeH="0" baseline="0" noProof="0" dirty="0" smtClean="0">
                  <a:ln>
                    <a:noFill/>
                  </a:ln>
                  <a:solidFill>
                    <a:srgbClr val="040503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rhIL-17A</a:t>
              </a:r>
              <a:r>
                <a:rPr kumimoji="0" lang="it-IT" sz="10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kumimoji="0" lang="it-IT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Rettangolo 69"/>
            <p:cNvSpPr/>
            <p:nvPr/>
          </p:nvSpPr>
          <p:spPr>
            <a:xfrm rot="16200000">
              <a:off x="4807116" y="2057778"/>
              <a:ext cx="734987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b="0" i="0" u="none" strike="noStrike" kern="0" cap="none" spc="0" normalizeH="0" baseline="0" noProof="0" dirty="0" smtClean="0">
                  <a:ln>
                    <a:noFill/>
                  </a:ln>
                  <a:solidFill>
                    <a:srgbClr val="040503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LMW-HA </a:t>
              </a: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b="0" i="0" u="none" strike="noStrike" kern="0" cap="none" spc="0" normalizeH="0" baseline="0" noProof="0" dirty="0" smtClean="0">
                  <a:ln>
                    <a:noFill/>
                  </a:ln>
                  <a:solidFill>
                    <a:srgbClr val="040503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rhIL-17A</a:t>
              </a:r>
              <a:r>
                <a:rPr kumimoji="0" lang="it-IT" sz="10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kumimoji="0" lang="it-IT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Rettangolo 70"/>
            <p:cNvSpPr/>
            <p:nvPr/>
          </p:nvSpPr>
          <p:spPr>
            <a:xfrm rot="16200000">
              <a:off x="5810690" y="2036544"/>
              <a:ext cx="692519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b="0" i="0" u="none" strike="noStrike" kern="0" cap="none" spc="0" normalizeH="0" baseline="0" noProof="0" dirty="0" smtClean="0">
                  <a:ln>
                    <a:noFill/>
                  </a:ln>
                  <a:solidFill>
                    <a:srgbClr val="040503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U0126</a:t>
              </a: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b="0" i="0" u="none" strike="noStrike" kern="0" cap="none" spc="0" normalizeH="0" baseline="0" noProof="0" dirty="0" smtClean="0">
                  <a:ln>
                    <a:noFill/>
                  </a:ln>
                  <a:solidFill>
                    <a:srgbClr val="040503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rhIL-17A</a:t>
              </a:r>
              <a:r>
                <a:rPr kumimoji="0" lang="it-IT" sz="10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kumimoji="0" lang="it-IT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Rettangolo 71"/>
            <p:cNvSpPr/>
            <p:nvPr/>
          </p:nvSpPr>
          <p:spPr>
            <a:xfrm rot="16200000">
              <a:off x="5311220" y="2112347"/>
              <a:ext cx="690237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b="0" i="0" u="none" strike="noStrike" kern="0" cap="none" spc="0" normalizeH="0" baseline="0" noProof="0" dirty="0" smtClean="0">
                  <a:ln>
                    <a:noFill/>
                  </a:ln>
                  <a:solidFill>
                    <a:srgbClr val="040503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PMA</a:t>
              </a:r>
              <a:endParaRPr kumimoji="0" lang="it-IT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Rettangolo 72"/>
            <p:cNvSpPr/>
            <p:nvPr/>
          </p:nvSpPr>
          <p:spPr>
            <a:xfrm rot="16200000">
              <a:off x="6351464" y="2112347"/>
              <a:ext cx="690237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b="0" i="0" u="none" strike="noStrike" kern="0" cap="none" spc="0" normalizeH="0" baseline="0" noProof="0" dirty="0" smtClean="0">
                  <a:ln>
                    <a:noFill/>
                  </a:ln>
                  <a:solidFill>
                    <a:srgbClr val="040503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rhIL-17A</a:t>
              </a:r>
              <a:r>
                <a:rPr kumimoji="0" lang="it-IT" sz="10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kumimoji="0" lang="it-IT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CasellaDiTesto 73"/>
            <p:cNvSpPr txBox="1"/>
            <p:nvPr/>
          </p:nvSpPr>
          <p:spPr>
            <a:xfrm rot="16200000">
              <a:off x="3071635" y="2074554"/>
              <a:ext cx="76853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Untreated</a:t>
              </a:r>
              <a:r>
                <a:rPr kumimoji="0" lang="it-IT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/>
              </a:r>
              <a:br>
                <a:rPr kumimoji="0" lang="it-IT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</a:br>
              <a:r>
                <a:rPr kumimoji="0" lang="it-IT" sz="10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ells</a:t>
              </a:r>
              <a:r>
                <a:rPr kumimoji="0" lang="it-IT" sz="10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 </a:t>
              </a:r>
              <a:endParaRPr kumimoji="0" lang="it-IT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5" name="Rettangolo 74"/>
          <p:cNvSpPr/>
          <p:nvPr/>
        </p:nvSpPr>
        <p:spPr>
          <a:xfrm>
            <a:off x="968198" y="830583"/>
            <a:ext cx="76174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800" b="0" i="0" u="none" strike="noStrike" kern="0" cap="none" spc="0" normalizeH="0" baseline="0" noProof="0" dirty="0" err="1">
                <a:ln>
                  <a:noFill/>
                </a:ln>
                <a:solidFill>
                  <a:srgbClr val="040503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pERK</a:t>
            </a:r>
            <a:endParaRPr kumimoji="0" lang="it-IT" sz="1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76" name="Rettangolo 75"/>
          <p:cNvSpPr/>
          <p:nvPr/>
        </p:nvSpPr>
        <p:spPr>
          <a:xfrm>
            <a:off x="935454" y="2418486"/>
            <a:ext cx="8915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l-GR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β</a:t>
            </a:r>
            <a:r>
              <a:rPr kumimoji="0" lang="it-IT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kumimoji="0" lang="it-IT" sz="18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r>
              <a:rPr kumimoji="0" lang="it-IT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0" lang="it-IT" sz="1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pic>
        <p:nvPicPr>
          <p:cNvPr id="77" name="Immagine 7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30681" y="197706"/>
            <a:ext cx="1979075" cy="1288391"/>
          </a:xfrm>
          <a:prstGeom prst="rect">
            <a:avLst/>
          </a:prstGeom>
        </p:spPr>
      </p:pic>
      <p:pic>
        <p:nvPicPr>
          <p:cNvPr id="78" name="Immagine 7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337241" y="1593085"/>
            <a:ext cx="1755207" cy="1512775"/>
          </a:xfrm>
          <a:prstGeom prst="rect">
            <a:avLst/>
          </a:prstGeom>
        </p:spPr>
      </p:pic>
      <p:sp>
        <p:nvSpPr>
          <p:cNvPr id="79" name="CasellaDiTesto 78"/>
          <p:cNvSpPr txBox="1"/>
          <p:nvPr/>
        </p:nvSpPr>
        <p:spPr>
          <a:xfrm>
            <a:off x="4683763" y="550995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Lane 1</a:t>
            </a:r>
            <a:endParaRPr kumimoji="0" lang="it-IT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80" name="CasellaDiTesto 79"/>
          <p:cNvSpPr txBox="1"/>
          <p:nvPr/>
        </p:nvSpPr>
        <p:spPr>
          <a:xfrm>
            <a:off x="8450193" y="550995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Lane 2</a:t>
            </a:r>
            <a:endParaRPr kumimoji="0" lang="it-IT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81" name="CasellaDiTesto 80"/>
          <p:cNvSpPr txBox="1"/>
          <p:nvPr/>
        </p:nvSpPr>
        <p:spPr>
          <a:xfrm>
            <a:off x="7364664" y="550995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Lane 3</a:t>
            </a:r>
            <a:endParaRPr kumimoji="0" lang="it-IT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82" name="CasellaDiTesto 81"/>
          <p:cNvSpPr txBox="1"/>
          <p:nvPr/>
        </p:nvSpPr>
        <p:spPr>
          <a:xfrm>
            <a:off x="7901616" y="550995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Lane 4</a:t>
            </a:r>
            <a:endParaRPr kumimoji="0" lang="it-IT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83" name="Rettangolo 82"/>
          <p:cNvSpPr/>
          <p:nvPr/>
        </p:nvSpPr>
        <p:spPr>
          <a:xfrm>
            <a:off x="4671630" y="550995"/>
            <a:ext cx="538239" cy="1902647"/>
          </a:xfrm>
          <a:prstGeom prst="rect">
            <a:avLst/>
          </a:prstGeom>
          <a:noFill/>
          <a:ln w="12700" cap="flat" cmpd="sng" algn="ctr">
            <a:solidFill>
              <a:srgbClr val="FF0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it-IT" sz="1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84" name="Rettangolo 83"/>
          <p:cNvSpPr/>
          <p:nvPr/>
        </p:nvSpPr>
        <p:spPr>
          <a:xfrm>
            <a:off x="7405861" y="552787"/>
            <a:ext cx="984517" cy="1902647"/>
          </a:xfrm>
          <a:prstGeom prst="rect">
            <a:avLst/>
          </a:prstGeom>
          <a:noFill/>
          <a:ln w="12700" cap="flat" cmpd="sng" algn="ctr">
            <a:solidFill>
              <a:srgbClr val="FF0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it-IT" sz="1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86" name="Rettangolo 85"/>
          <p:cNvSpPr/>
          <p:nvPr/>
        </p:nvSpPr>
        <p:spPr>
          <a:xfrm>
            <a:off x="8429633" y="543823"/>
            <a:ext cx="508285" cy="1902647"/>
          </a:xfrm>
          <a:prstGeom prst="rect">
            <a:avLst/>
          </a:prstGeom>
          <a:noFill/>
          <a:ln w="12700" cap="flat" cmpd="sng" algn="ctr">
            <a:solidFill>
              <a:srgbClr val="FF0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it-IT" sz="1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87" name="Immagine 8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324405" y="3349010"/>
            <a:ext cx="2947322" cy="1324059"/>
          </a:xfrm>
          <a:prstGeom prst="rect">
            <a:avLst/>
          </a:prstGeom>
        </p:spPr>
      </p:pic>
      <p:sp>
        <p:nvSpPr>
          <p:cNvPr id="88" name="Rettangolo 87"/>
          <p:cNvSpPr/>
          <p:nvPr/>
        </p:nvSpPr>
        <p:spPr>
          <a:xfrm>
            <a:off x="599039" y="3971830"/>
            <a:ext cx="148059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>
              <a:spcBef>
                <a:spcPct val="0"/>
              </a:spcBef>
              <a:defRPr/>
            </a:pPr>
            <a:r>
              <a:rPr lang="it-IT" altLang="it-IT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it-IT" altLang="it-IT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kba</a:t>
            </a:r>
            <a:endParaRPr lang="it-IT" altLang="it-IT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CasellaDiTesto 88"/>
          <p:cNvSpPr txBox="1"/>
          <p:nvPr/>
        </p:nvSpPr>
        <p:spPr>
          <a:xfrm>
            <a:off x="1339335" y="5513334"/>
            <a:ext cx="504946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sz="1400" dirty="0" smtClean="0"/>
              <a:t>β</a:t>
            </a:r>
            <a:r>
              <a:rPr lang="it-IT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it-IT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it-IT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0" name="Immagine 8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291307" y="4821002"/>
            <a:ext cx="2813442" cy="1653892"/>
          </a:xfrm>
          <a:prstGeom prst="rect">
            <a:avLst/>
          </a:prstGeom>
        </p:spPr>
      </p:pic>
      <p:grpSp>
        <p:nvGrpSpPr>
          <p:cNvPr id="91" name="Gruppo 90"/>
          <p:cNvGrpSpPr/>
          <p:nvPr/>
        </p:nvGrpSpPr>
        <p:grpSpPr>
          <a:xfrm>
            <a:off x="5876841" y="4164929"/>
            <a:ext cx="5749573" cy="1706091"/>
            <a:chOff x="5876841" y="4337057"/>
            <a:chExt cx="5749573" cy="1706091"/>
          </a:xfrm>
        </p:grpSpPr>
        <p:sp>
          <p:nvSpPr>
            <p:cNvPr id="92" name="Rettangolo 91"/>
            <p:cNvSpPr/>
            <p:nvPr/>
          </p:nvSpPr>
          <p:spPr>
            <a:xfrm rot="16200000">
              <a:off x="7311996" y="5426854"/>
              <a:ext cx="832478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it-IT" sz="1000" b="0" i="0" dirty="0" smtClean="0">
                  <a:solidFill>
                    <a:srgbClr val="04050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MW-HA </a:t>
              </a:r>
            </a:p>
            <a:p>
              <a:pPr algn="ctr"/>
              <a:r>
                <a:rPr lang="it-IT" sz="1000" b="0" i="0" dirty="0" smtClean="0">
                  <a:solidFill>
                    <a:srgbClr val="04050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hIL-17A</a:t>
              </a:r>
              <a:r>
                <a:rPr lang="it-IT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it-IT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93" name="Gruppo 92"/>
            <p:cNvGrpSpPr/>
            <p:nvPr/>
          </p:nvGrpSpPr>
          <p:grpSpPr>
            <a:xfrm>
              <a:off x="5876841" y="4337057"/>
              <a:ext cx="5749573" cy="1642151"/>
              <a:chOff x="5571462" y="1726060"/>
              <a:chExt cx="5749573" cy="1642151"/>
            </a:xfrm>
          </p:grpSpPr>
          <p:grpSp>
            <p:nvGrpSpPr>
              <p:cNvPr id="95" name="Gruppo 94"/>
              <p:cNvGrpSpPr/>
              <p:nvPr/>
            </p:nvGrpSpPr>
            <p:grpSpPr>
              <a:xfrm>
                <a:off x="5571462" y="1726060"/>
                <a:ext cx="5749573" cy="866433"/>
                <a:chOff x="6134984" y="1723508"/>
                <a:chExt cx="5187608" cy="797093"/>
              </a:xfrm>
            </p:grpSpPr>
            <p:pic>
              <p:nvPicPr>
                <p:cNvPr id="103" name="Immagine 102"/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6134984" y="1723508"/>
                  <a:ext cx="3830601" cy="351540"/>
                </a:xfrm>
                <a:prstGeom prst="rect">
                  <a:avLst/>
                </a:prstGeom>
                <a:ln>
                  <a:noFill/>
                </a:ln>
              </p:spPr>
            </p:pic>
            <p:sp>
              <p:nvSpPr>
                <p:cNvPr id="104" name="Rettangolo 103"/>
                <p:cNvSpPr/>
                <p:nvPr/>
              </p:nvSpPr>
              <p:spPr>
                <a:xfrm>
                  <a:off x="9895568" y="1762648"/>
                  <a:ext cx="1335879" cy="283146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r">
                    <a:spcBef>
                      <a:spcPct val="0"/>
                    </a:spcBef>
                    <a:defRPr/>
                  </a:pPr>
                  <a:r>
                    <a:rPr lang="it-IT" altLang="it-IT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-</a:t>
                  </a:r>
                  <a:r>
                    <a:rPr lang="it-IT" altLang="it-IT" sz="140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kba</a:t>
                  </a:r>
                  <a:r>
                    <a:rPr lang="it-IT" altLang="it-IT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(40 </a:t>
                  </a:r>
                  <a:r>
                    <a:rPr lang="it-IT" altLang="it-IT" sz="140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r>
                    <a:rPr lang="it-IT" altLang="it-IT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)</a:t>
                  </a:r>
                </a:p>
              </p:txBody>
            </p:sp>
            <p:sp>
              <p:nvSpPr>
                <p:cNvPr id="105" name="CasellaDiTesto 104"/>
                <p:cNvSpPr txBox="1"/>
                <p:nvPr/>
              </p:nvSpPr>
              <p:spPr>
                <a:xfrm>
                  <a:off x="10049808" y="2305157"/>
                  <a:ext cx="1272784" cy="215444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r>
                    <a:rPr lang="el-GR" sz="1400" dirty="0" smtClean="0"/>
                    <a:t>β</a:t>
                  </a:r>
                  <a:r>
                    <a:rPr lang="it-IT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</a:t>
                  </a:r>
                  <a:r>
                    <a:rPr lang="it-IT" sz="14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ctin</a:t>
                  </a:r>
                  <a:r>
                    <a:rPr lang="it-IT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lang="it-IT" sz="1400" b="0" i="0" dirty="0" smtClean="0">
                      <a:solidFill>
                        <a:srgbClr val="040503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(42 </a:t>
                  </a:r>
                  <a:r>
                    <a:rPr lang="it-IT" sz="1400" b="0" i="0" dirty="0" err="1" smtClean="0">
                      <a:solidFill>
                        <a:srgbClr val="040503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r>
                    <a:rPr lang="it-IT" sz="1400" b="0" i="0" dirty="0" smtClean="0">
                      <a:solidFill>
                        <a:srgbClr val="040503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)</a:t>
                  </a:r>
                  <a:r>
                    <a:rPr lang="it-IT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endParaRPr lang="it-IT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96" name="Rettangolo 95"/>
              <p:cNvSpPr/>
              <p:nvPr/>
            </p:nvSpPr>
            <p:spPr>
              <a:xfrm rot="16200000">
                <a:off x="6537680" y="2773743"/>
                <a:ext cx="748251" cy="40011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it-IT" sz="1000" b="0" i="0" dirty="0" smtClean="0">
                    <a:solidFill>
                      <a:srgbClr val="040503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MW-HA </a:t>
                </a:r>
              </a:p>
              <a:p>
                <a:pPr algn="ctr"/>
                <a:r>
                  <a:rPr lang="it-IT" sz="1000" b="0" i="0" dirty="0" smtClean="0">
                    <a:solidFill>
                      <a:srgbClr val="040503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hIL-17A</a:t>
                </a:r>
                <a:r>
                  <a:rPr lang="it-IT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it-IT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7" name="Rettangolo 96"/>
              <p:cNvSpPr/>
              <p:nvPr/>
            </p:nvSpPr>
            <p:spPr>
              <a:xfrm rot="16200000">
                <a:off x="7545272" y="2767111"/>
                <a:ext cx="734987" cy="40011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it-IT" sz="1000" b="0" i="0" dirty="0" smtClean="0">
                    <a:solidFill>
                      <a:srgbClr val="040503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MW-HA </a:t>
                </a:r>
              </a:p>
              <a:p>
                <a:pPr algn="ctr"/>
                <a:r>
                  <a:rPr lang="it-IT" sz="1000" b="0" i="0" dirty="0" smtClean="0">
                    <a:solidFill>
                      <a:srgbClr val="040503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hIL-17A</a:t>
                </a:r>
                <a:r>
                  <a:rPr lang="it-IT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it-IT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8" name="Rettangolo 97"/>
              <p:cNvSpPr/>
              <p:nvPr/>
            </p:nvSpPr>
            <p:spPr>
              <a:xfrm rot="16200000">
                <a:off x="9090256" y="2745877"/>
                <a:ext cx="692519" cy="40011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it-IT" sz="1000" b="0" i="0" dirty="0" smtClean="0">
                    <a:solidFill>
                      <a:srgbClr val="040503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0126</a:t>
                </a:r>
              </a:p>
              <a:p>
                <a:pPr algn="ctr"/>
                <a:r>
                  <a:rPr lang="it-IT" sz="1000" b="0" i="0" dirty="0" smtClean="0">
                    <a:solidFill>
                      <a:srgbClr val="040503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hIL-17A</a:t>
                </a:r>
                <a:r>
                  <a:rPr lang="it-IT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it-IT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9" name="Rettangolo 98"/>
              <p:cNvSpPr/>
              <p:nvPr/>
            </p:nvSpPr>
            <p:spPr>
              <a:xfrm rot="16200000">
                <a:off x="8560344" y="2821680"/>
                <a:ext cx="690237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it-IT" sz="1000" b="0" i="0" dirty="0" smtClean="0">
                    <a:solidFill>
                      <a:srgbClr val="040503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MA</a:t>
                </a:r>
                <a:endParaRPr lang="it-IT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" name="Rettangolo 99"/>
              <p:cNvSpPr/>
              <p:nvPr/>
            </p:nvSpPr>
            <p:spPr>
              <a:xfrm rot="16200000">
                <a:off x="8076309" y="2821680"/>
                <a:ext cx="690237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it-IT" sz="1000" b="0" i="0" dirty="0" smtClean="0">
                    <a:solidFill>
                      <a:srgbClr val="040503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hIL-17A</a:t>
                </a:r>
                <a:r>
                  <a:rPr lang="it-IT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it-IT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" name="CasellaDiTesto 100"/>
              <p:cNvSpPr txBox="1"/>
              <p:nvPr/>
            </p:nvSpPr>
            <p:spPr>
              <a:xfrm rot="16200000">
                <a:off x="5478026" y="2783887"/>
                <a:ext cx="768538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dirty="0" err="1"/>
                  <a:t>Untreated</a:t>
                </a:r>
                <a:r>
                  <a:rPr lang="it-IT" sz="1000" dirty="0"/>
                  <a:t/>
                </a:r>
                <a:br>
                  <a:rPr lang="it-IT" sz="1000" dirty="0"/>
                </a:br>
                <a:r>
                  <a:rPr lang="it-IT" sz="1000" dirty="0" err="1"/>
                  <a:t>cells</a:t>
                </a:r>
                <a:r>
                  <a:rPr lang="it-IT" sz="1000" dirty="0" smtClean="0"/>
                  <a:t> </a:t>
                </a:r>
                <a:endParaRPr lang="it-IT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2" name="Rettangolo 101"/>
              <p:cNvSpPr/>
              <p:nvPr/>
            </p:nvSpPr>
            <p:spPr>
              <a:xfrm rot="16200000">
                <a:off x="6041930" y="2821681"/>
                <a:ext cx="690237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it-IT" sz="1000" b="0" i="0" dirty="0" smtClean="0">
                    <a:solidFill>
                      <a:srgbClr val="040503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hIL-17A</a:t>
                </a:r>
                <a:r>
                  <a:rPr lang="it-IT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it-IT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94" name="Immagine 93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876841" y="4745952"/>
              <a:ext cx="4234191" cy="362877"/>
            </a:xfrm>
            <a:prstGeom prst="rect">
              <a:avLst/>
            </a:prstGeom>
            <a:ln>
              <a:noFill/>
            </a:ln>
          </p:spPr>
        </p:pic>
      </p:grpSp>
      <p:sp>
        <p:nvSpPr>
          <p:cNvPr id="106" name="CasellaDiTesto 105"/>
          <p:cNvSpPr txBox="1"/>
          <p:nvPr/>
        </p:nvSpPr>
        <p:spPr>
          <a:xfrm>
            <a:off x="5923215" y="3868891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/>
              <a:t>Lane 1</a:t>
            </a:r>
            <a:endParaRPr lang="it-IT" sz="1000" dirty="0"/>
          </a:p>
        </p:txBody>
      </p:sp>
      <p:sp>
        <p:nvSpPr>
          <p:cNvPr id="107" name="CasellaDiTesto 106"/>
          <p:cNvSpPr txBox="1"/>
          <p:nvPr/>
        </p:nvSpPr>
        <p:spPr>
          <a:xfrm>
            <a:off x="6445859" y="3868891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/>
              <a:t>Lane 2</a:t>
            </a:r>
            <a:endParaRPr lang="it-IT" sz="1000" dirty="0"/>
          </a:p>
        </p:txBody>
      </p:sp>
      <p:sp>
        <p:nvSpPr>
          <p:cNvPr id="108" name="CasellaDiTesto 107"/>
          <p:cNvSpPr txBox="1"/>
          <p:nvPr/>
        </p:nvSpPr>
        <p:spPr>
          <a:xfrm>
            <a:off x="9059347" y="3868891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/>
              <a:t>Lane 3</a:t>
            </a:r>
            <a:endParaRPr lang="it-IT" sz="1000" dirty="0"/>
          </a:p>
        </p:txBody>
      </p:sp>
      <p:sp>
        <p:nvSpPr>
          <p:cNvPr id="109" name="CasellaDiTesto 108"/>
          <p:cNvSpPr txBox="1"/>
          <p:nvPr/>
        </p:nvSpPr>
        <p:spPr>
          <a:xfrm>
            <a:off x="9596299" y="3868891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/>
              <a:t>Lane 4</a:t>
            </a:r>
            <a:endParaRPr lang="it-IT" sz="1000" dirty="0"/>
          </a:p>
        </p:txBody>
      </p:sp>
      <p:sp>
        <p:nvSpPr>
          <p:cNvPr id="110" name="Rettangolo 109"/>
          <p:cNvSpPr/>
          <p:nvPr/>
        </p:nvSpPr>
        <p:spPr>
          <a:xfrm>
            <a:off x="5898554" y="3873637"/>
            <a:ext cx="1118575" cy="190264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11" name="Rettangolo 110"/>
          <p:cNvSpPr/>
          <p:nvPr/>
        </p:nvSpPr>
        <p:spPr>
          <a:xfrm>
            <a:off x="9062801" y="3868891"/>
            <a:ext cx="1118575" cy="190264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940038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8" name="Gruppo 57"/>
          <p:cNvGrpSpPr/>
          <p:nvPr/>
        </p:nvGrpSpPr>
        <p:grpSpPr>
          <a:xfrm>
            <a:off x="5416745" y="4430643"/>
            <a:ext cx="6297532" cy="1804050"/>
            <a:chOff x="3385073" y="3510929"/>
            <a:chExt cx="6297532" cy="1804050"/>
          </a:xfrm>
        </p:grpSpPr>
        <p:pic>
          <p:nvPicPr>
            <p:cNvPr id="59" name="Immagine 58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385073" y="3510929"/>
              <a:ext cx="4923795" cy="423617"/>
            </a:xfrm>
            <a:prstGeom prst="rect">
              <a:avLst/>
            </a:prstGeom>
            <a:ln>
              <a:noFill/>
            </a:ln>
          </p:spPr>
        </p:pic>
        <p:sp>
          <p:nvSpPr>
            <p:cNvPr id="60" name="CasellaDiTesto 59"/>
            <p:cNvSpPr txBox="1"/>
            <p:nvPr/>
          </p:nvSpPr>
          <p:spPr>
            <a:xfrm>
              <a:off x="8409821" y="4111993"/>
              <a:ext cx="1272784" cy="215444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l-GR" sz="1400" dirty="0" smtClean="0"/>
                <a:t>β</a:t>
              </a:r>
              <a:r>
                <a:rPr lang="it-IT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lang="it-IT" sz="14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tin</a:t>
              </a:r>
              <a:r>
                <a:rPr lang="it-IT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1400" b="0" i="0" dirty="0" smtClean="0">
                  <a:solidFill>
                    <a:srgbClr val="04050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42 </a:t>
              </a:r>
              <a:r>
                <a:rPr lang="it-IT" sz="1400" b="0" i="0" dirty="0" err="1" smtClean="0">
                  <a:solidFill>
                    <a:srgbClr val="04050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r>
                <a:rPr lang="it-IT" sz="1400" b="0" i="0" dirty="0" smtClean="0">
                  <a:solidFill>
                    <a:srgbClr val="04050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r>
                <a:rPr lang="it-IT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it-IT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Rettangolo 60"/>
            <p:cNvSpPr/>
            <p:nvPr/>
          </p:nvSpPr>
          <p:spPr>
            <a:xfrm>
              <a:off x="8438265" y="3581254"/>
              <a:ext cx="1172148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it-IT" sz="1400" b="0" i="0" dirty="0" smtClean="0">
                  <a:solidFill>
                    <a:srgbClr val="04050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L-8 (8 </a:t>
              </a:r>
              <a:r>
                <a:rPr lang="it-IT" sz="1400" b="0" i="0" dirty="0" err="1" smtClean="0">
                  <a:solidFill>
                    <a:srgbClr val="04050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r>
                <a:rPr lang="it-IT" sz="1400" b="0" i="0" dirty="0" smtClean="0">
                  <a:solidFill>
                    <a:srgbClr val="04050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r>
                <a:rPr lang="it-IT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it-IT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CasellaDiTesto 61"/>
            <p:cNvSpPr txBox="1"/>
            <p:nvPr/>
          </p:nvSpPr>
          <p:spPr>
            <a:xfrm rot="16200000">
              <a:off x="3341592" y="4602167"/>
              <a:ext cx="76853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dirty="0" err="1"/>
                <a:t>Untreated</a:t>
              </a:r>
              <a:r>
                <a:rPr lang="it-IT" sz="1000" dirty="0"/>
                <a:t/>
              </a:r>
              <a:br>
                <a:rPr lang="it-IT" sz="1000" dirty="0"/>
              </a:br>
              <a:r>
                <a:rPr lang="it-IT" sz="1000" dirty="0" err="1"/>
                <a:t>cells</a:t>
              </a:r>
              <a:r>
                <a:rPr lang="it-IT" sz="1000" dirty="0" smtClean="0"/>
                <a:t> </a:t>
              </a:r>
              <a:endParaRPr lang="it-IT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Rettangolo 62"/>
            <p:cNvSpPr/>
            <p:nvPr/>
          </p:nvSpPr>
          <p:spPr>
            <a:xfrm rot="16200000">
              <a:off x="3915534" y="4639961"/>
              <a:ext cx="690237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it-IT" sz="1000" b="0" i="0" dirty="0" smtClean="0">
                  <a:solidFill>
                    <a:srgbClr val="04050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hIL-17A</a:t>
              </a:r>
              <a:r>
                <a:rPr lang="it-IT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it-IT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Rettangolo 63"/>
            <p:cNvSpPr/>
            <p:nvPr/>
          </p:nvSpPr>
          <p:spPr>
            <a:xfrm rot="16200000">
              <a:off x="4404103" y="4656571"/>
              <a:ext cx="748251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it-IT" sz="1000" b="0" i="0" dirty="0" smtClean="0">
                  <a:solidFill>
                    <a:srgbClr val="04050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MW-HA </a:t>
              </a:r>
            </a:p>
            <a:p>
              <a:r>
                <a:rPr lang="it-IT" sz="1000" b="0" i="0" dirty="0" smtClean="0">
                  <a:solidFill>
                    <a:srgbClr val="04050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hIL-17A</a:t>
              </a:r>
              <a:r>
                <a:rPr lang="it-IT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it-IT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Rettangolo 64"/>
            <p:cNvSpPr/>
            <p:nvPr/>
          </p:nvSpPr>
          <p:spPr>
            <a:xfrm rot="16200000">
              <a:off x="4937648" y="4698685"/>
              <a:ext cx="832478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it-IT" sz="1000" b="0" i="0" dirty="0" smtClean="0">
                  <a:solidFill>
                    <a:srgbClr val="04050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MW-HA </a:t>
              </a:r>
            </a:p>
            <a:p>
              <a:pPr algn="ctr"/>
              <a:r>
                <a:rPr lang="it-IT" sz="1000" b="0" i="0" dirty="0" smtClean="0">
                  <a:solidFill>
                    <a:srgbClr val="04050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hIL-17A</a:t>
              </a:r>
              <a:r>
                <a:rPr lang="it-IT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it-IT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Rettangolo 65"/>
            <p:cNvSpPr/>
            <p:nvPr/>
          </p:nvSpPr>
          <p:spPr>
            <a:xfrm rot="16200000">
              <a:off x="5565105" y="4649939"/>
              <a:ext cx="734987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it-IT" sz="1000" b="0" i="0" dirty="0" smtClean="0">
                  <a:solidFill>
                    <a:srgbClr val="04050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MW-HA </a:t>
              </a:r>
            </a:p>
            <a:p>
              <a:r>
                <a:rPr lang="it-IT" sz="1000" b="0" i="0" dirty="0" smtClean="0">
                  <a:solidFill>
                    <a:srgbClr val="04050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hIL-17A</a:t>
              </a:r>
              <a:r>
                <a:rPr lang="it-IT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it-IT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Rettangolo 66"/>
            <p:cNvSpPr/>
            <p:nvPr/>
          </p:nvSpPr>
          <p:spPr>
            <a:xfrm rot="16200000">
              <a:off x="7630888" y="4628705"/>
              <a:ext cx="692519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it-IT" sz="1000" b="0" i="0" dirty="0" smtClean="0">
                  <a:solidFill>
                    <a:srgbClr val="04050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U0126</a:t>
              </a:r>
            </a:p>
            <a:p>
              <a:pPr algn="ctr"/>
              <a:r>
                <a:rPr lang="it-IT" sz="1000" b="0" i="0" dirty="0" smtClean="0">
                  <a:solidFill>
                    <a:srgbClr val="04050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hIL-17A</a:t>
              </a:r>
              <a:r>
                <a:rPr lang="it-IT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it-IT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Rettangolo 67"/>
            <p:cNvSpPr/>
            <p:nvPr/>
          </p:nvSpPr>
          <p:spPr>
            <a:xfrm rot="16200000">
              <a:off x="6069209" y="4704509"/>
              <a:ext cx="690237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it-IT" sz="1000" b="0" i="0" dirty="0" smtClean="0">
                  <a:solidFill>
                    <a:srgbClr val="04050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hIL-17A</a:t>
              </a:r>
              <a:r>
                <a:rPr lang="it-IT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it-IT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69" name="Immagine 68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385074" y="4012030"/>
              <a:ext cx="4923795" cy="428625"/>
            </a:xfrm>
            <a:prstGeom prst="rect">
              <a:avLst/>
            </a:prstGeom>
            <a:ln>
              <a:noFill/>
            </a:ln>
          </p:spPr>
        </p:pic>
        <p:sp>
          <p:nvSpPr>
            <p:cNvPr id="70" name="Rettangolo 69"/>
            <p:cNvSpPr/>
            <p:nvPr/>
          </p:nvSpPr>
          <p:spPr>
            <a:xfrm rot="16200000">
              <a:off x="7098341" y="4628705"/>
              <a:ext cx="692519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it-IT" sz="1000" b="0" i="0" dirty="0" smtClean="0">
                  <a:solidFill>
                    <a:srgbClr val="04050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U0126</a:t>
              </a:r>
            </a:p>
            <a:p>
              <a:pPr algn="ctr"/>
              <a:r>
                <a:rPr lang="it-IT" sz="1000" b="0" i="0" dirty="0" smtClean="0">
                  <a:solidFill>
                    <a:srgbClr val="04050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hIL-17A</a:t>
              </a:r>
              <a:r>
                <a:rPr lang="it-IT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it-IT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Rettangolo 70"/>
            <p:cNvSpPr/>
            <p:nvPr/>
          </p:nvSpPr>
          <p:spPr>
            <a:xfrm rot="16200000">
              <a:off x="6643880" y="4704509"/>
              <a:ext cx="690237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it-IT" sz="1000" b="0" i="0" dirty="0" smtClean="0">
                  <a:solidFill>
                    <a:srgbClr val="04050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hIL-17A</a:t>
              </a:r>
              <a:r>
                <a:rPr lang="it-IT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it-IT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2" name="CasellaDiTesto 71"/>
          <p:cNvSpPr txBox="1"/>
          <p:nvPr/>
        </p:nvSpPr>
        <p:spPr>
          <a:xfrm>
            <a:off x="1187455" y="3737988"/>
            <a:ext cx="5020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L-8</a:t>
            </a:r>
            <a:endParaRPr lang="it-IT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Rettangolo 72"/>
          <p:cNvSpPr/>
          <p:nvPr/>
        </p:nvSpPr>
        <p:spPr>
          <a:xfrm>
            <a:off x="581022" y="6043775"/>
            <a:ext cx="73449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sz="1400" dirty="0"/>
              <a:t>β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it-IT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it-IT" sz="1400" dirty="0"/>
          </a:p>
        </p:txBody>
      </p:sp>
      <p:pic>
        <p:nvPicPr>
          <p:cNvPr id="74" name="Immagine 7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26260" y="3223935"/>
            <a:ext cx="2886263" cy="1430797"/>
          </a:xfrm>
          <a:prstGeom prst="rect">
            <a:avLst/>
          </a:prstGeom>
        </p:spPr>
      </p:pic>
      <p:pic>
        <p:nvPicPr>
          <p:cNvPr id="75" name="Immagine 7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38486" y="4701068"/>
            <a:ext cx="3263348" cy="2092529"/>
          </a:xfrm>
          <a:prstGeom prst="rect">
            <a:avLst/>
          </a:prstGeom>
        </p:spPr>
      </p:pic>
      <p:sp>
        <p:nvSpPr>
          <p:cNvPr id="77" name="CasellaDiTesto 76"/>
          <p:cNvSpPr txBox="1"/>
          <p:nvPr/>
        </p:nvSpPr>
        <p:spPr>
          <a:xfrm>
            <a:off x="5504452" y="4113975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/>
              <a:t>Lane 1</a:t>
            </a:r>
            <a:endParaRPr lang="it-IT" sz="1000" dirty="0"/>
          </a:p>
        </p:txBody>
      </p:sp>
      <p:sp>
        <p:nvSpPr>
          <p:cNvPr id="78" name="CasellaDiTesto 77"/>
          <p:cNvSpPr txBox="1"/>
          <p:nvPr/>
        </p:nvSpPr>
        <p:spPr>
          <a:xfrm>
            <a:off x="6083739" y="4113975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/>
              <a:t>Lane 2</a:t>
            </a:r>
            <a:endParaRPr lang="it-IT" sz="1000" dirty="0"/>
          </a:p>
        </p:txBody>
      </p:sp>
      <p:sp>
        <p:nvSpPr>
          <p:cNvPr id="79" name="CasellaDiTesto 78"/>
          <p:cNvSpPr txBox="1"/>
          <p:nvPr/>
        </p:nvSpPr>
        <p:spPr>
          <a:xfrm>
            <a:off x="9225885" y="4113975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/>
              <a:t>Lane 3</a:t>
            </a:r>
            <a:endParaRPr lang="it-IT" sz="1000" dirty="0"/>
          </a:p>
        </p:txBody>
      </p:sp>
      <p:sp>
        <p:nvSpPr>
          <p:cNvPr id="80" name="Rettangolo 79"/>
          <p:cNvSpPr/>
          <p:nvPr/>
        </p:nvSpPr>
        <p:spPr>
          <a:xfrm>
            <a:off x="5468242" y="4045765"/>
            <a:ext cx="1118575" cy="190264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81" name="Rettangolo 80"/>
          <p:cNvSpPr/>
          <p:nvPr/>
        </p:nvSpPr>
        <p:spPr>
          <a:xfrm>
            <a:off x="9214155" y="4101321"/>
            <a:ext cx="538239" cy="190264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82" name="Immagine 8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756652" y="859110"/>
            <a:ext cx="3840745" cy="434947"/>
          </a:xfrm>
          <a:prstGeom prst="rect">
            <a:avLst/>
          </a:prstGeom>
          <a:ln>
            <a:noFill/>
          </a:ln>
        </p:spPr>
      </p:pic>
      <p:sp>
        <p:nvSpPr>
          <p:cNvPr id="83" name="CasellaDiTesto 82"/>
          <p:cNvSpPr txBox="1"/>
          <p:nvPr/>
        </p:nvSpPr>
        <p:spPr>
          <a:xfrm>
            <a:off x="7204322" y="175972"/>
            <a:ext cx="108529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endParaRPr lang="it-IT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it-IT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2b</a:t>
            </a:r>
            <a:endParaRPr lang="it-IT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CasellaDiTesto 83"/>
          <p:cNvSpPr txBox="1"/>
          <p:nvPr/>
        </p:nvSpPr>
        <p:spPr>
          <a:xfrm rot="16200000">
            <a:off x="5745117" y="1912612"/>
            <a:ext cx="76853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dirty="0" err="1"/>
              <a:t>Untreated</a:t>
            </a:r>
            <a:r>
              <a:rPr lang="it-IT" sz="1000" dirty="0"/>
              <a:t/>
            </a:r>
            <a:br>
              <a:rPr lang="it-IT" sz="1000" dirty="0"/>
            </a:br>
            <a:r>
              <a:rPr lang="it-IT" sz="1000" dirty="0" err="1"/>
              <a:t>cells</a:t>
            </a:r>
            <a:r>
              <a:rPr lang="it-IT" sz="1000" dirty="0" smtClean="0"/>
              <a:t> </a:t>
            </a:r>
            <a:endParaRPr lang="it-IT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Rettangolo 84"/>
          <p:cNvSpPr/>
          <p:nvPr/>
        </p:nvSpPr>
        <p:spPr>
          <a:xfrm rot="16200000">
            <a:off x="8817752" y="1950406"/>
            <a:ext cx="690237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000" b="0" i="0" dirty="0" smtClean="0">
                <a:solidFill>
                  <a:srgbClr val="040503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hIL-17A</a:t>
            </a:r>
            <a:r>
              <a:rPr lang="it-IT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it-IT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Rettangolo 85"/>
          <p:cNvSpPr/>
          <p:nvPr/>
        </p:nvSpPr>
        <p:spPr>
          <a:xfrm rot="16200000">
            <a:off x="8201356" y="2033801"/>
            <a:ext cx="1010916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it-IT" sz="1000" dirty="0">
                <a:solidFill>
                  <a:srgbClr val="04050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hIL-17A </a:t>
            </a:r>
            <a:r>
              <a:rPr lang="it-IT" sz="1000" dirty="0" smtClean="0">
                <a:solidFill>
                  <a:srgbClr val="04050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it-IT" sz="1000" dirty="0" err="1">
                <a:solidFill>
                  <a:srgbClr val="04050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lang="it-IT" sz="1000" dirty="0" err="1" smtClean="0">
                <a:solidFill>
                  <a:srgbClr val="04050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ading</a:t>
            </a:r>
            <a:r>
              <a:rPr lang="it-IT" sz="1000" dirty="0" smtClean="0">
                <a:solidFill>
                  <a:srgbClr val="04050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000" b="0" i="0" dirty="0" err="1" smtClean="0">
                <a:solidFill>
                  <a:srgbClr val="040503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rror</a:t>
            </a:r>
            <a:r>
              <a:rPr lang="it-IT" sz="1000" b="0" i="0" dirty="0" smtClean="0">
                <a:solidFill>
                  <a:srgbClr val="040503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it-IT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it-IT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Rettangolo 86"/>
          <p:cNvSpPr/>
          <p:nvPr/>
        </p:nvSpPr>
        <p:spPr>
          <a:xfrm rot="16200000">
            <a:off x="6830197" y="1902469"/>
            <a:ext cx="748251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000" b="0" i="0" dirty="0" smtClean="0">
                <a:solidFill>
                  <a:srgbClr val="040503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HMW-HA </a:t>
            </a:r>
          </a:p>
          <a:p>
            <a:r>
              <a:rPr lang="it-IT" sz="1000" b="0" i="0" dirty="0" smtClean="0">
                <a:solidFill>
                  <a:srgbClr val="040503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hIL-17A</a:t>
            </a:r>
            <a:r>
              <a:rPr lang="it-IT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it-IT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Rettangolo 87"/>
          <p:cNvSpPr/>
          <p:nvPr/>
        </p:nvSpPr>
        <p:spPr>
          <a:xfrm rot="16200000">
            <a:off x="7248447" y="1944582"/>
            <a:ext cx="832478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it-IT" sz="1000" b="0" i="0" dirty="0" smtClean="0">
                <a:solidFill>
                  <a:srgbClr val="040503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MW-HA </a:t>
            </a:r>
          </a:p>
          <a:p>
            <a:pPr algn="ctr"/>
            <a:r>
              <a:rPr lang="it-IT" sz="1000" b="0" i="0" dirty="0" smtClean="0">
                <a:solidFill>
                  <a:srgbClr val="040503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hIL-17A</a:t>
            </a:r>
            <a:r>
              <a:rPr lang="it-IT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it-IT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Rettangolo 88"/>
          <p:cNvSpPr/>
          <p:nvPr/>
        </p:nvSpPr>
        <p:spPr>
          <a:xfrm rot="16200000">
            <a:off x="7795321" y="1895837"/>
            <a:ext cx="734987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000" b="0" i="0" dirty="0" smtClean="0">
                <a:solidFill>
                  <a:srgbClr val="040503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LMW-HA </a:t>
            </a:r>
          </a:p>
          <a:p>
            <a:r>
              <a:rPr lang="it-IT" sz="1000" b="0" i="0" dirty="0" smtClean="0">
                <a:solidFill>
                  <a:srgbClr val="040503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hIL-17A</a:t>
            </a:r>
            <a:r>
              <a:rPr lang="it-IT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it-IT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Rettangolo 89"/>
          <p:cNvSpPr/>
          <p:nvPr/>
        </p:nvSpPr>
        <p:spPr>
          <a:xfrm rot="16200000">
            <a:off x="6294821" y="1874603"/>
            <a:ext cx="69251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it-IT" sz="1000" b="0" i="0" dirty="0" smtClean="0">
                <a:solidFill>
                  <a:srgbClr val="040503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U0126</a:t>
            </a:r>
          </a:p>
          <a:p>
            <a:pPr algn="ctr"/>
            <a:r>
              <a:rPr lang="it-IT" sz="1000" b="0" i="0" dirty="0" smtClean="0">
                <a:solidFill>
                  <a:srgbClr val="040503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hIL-17A</a:t>
            </a:r>
            <a:r>
              <a:rPr lang="it-IT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it-IT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Rettangolo 90"/>
          <p:cNvSpPr/>
          <p:nvPr/>
        </p:nvSpPr>
        <p:spPr>
          <a:xfrm>
            <a:off x="9631180" y="900417"/>
            <a:ext cx="145670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it-IT" sz="1400" dirty="0">
                <a:solidFill>
                  <a:srgbClr val="04050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X-4 </a:t>
            </a:r>
            <a:r>
              <a:rPr lang="it-IT" sz="1400" b="0" i="0" dirty="0" smtClean="0">
                <a:solidFill>
                  <a:srgbClr val="040503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70 </a:t>
            </a:r>
            <a:r>
              <a:rPr lang="it-IT" sz="1400" b="0" i="0" dirty="0" err="1" smtClean="0">
                <a:solidFill>
                  <a:srgbClr val="040503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it-IT" sz="1400" b="0" i="0" dirty="0" smtClean="0">
                <a:solidFill>
                  <a:srgbClr val="040503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it-IT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it-IT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CasellaDiTesto 91"/>
          <p:cNvSpPr txBox="1"/>
          <p:nvPr/>
        </p:nvSpPr>
        <p:spPr>
          <a:xfrm>
            <a:off x="9721496" y="1492291"/>
            <a:ext cx="1272784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it-IT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it-IT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r>
              <a:rPr lang="it-IT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400" b="0" i="0" dirty="0" smtClean="0">
                <a:solidFill>
                  <a:srgbClr val="040503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42 </a:t>
            </a:r>
            <a:r>
              <a:rPr lang="it-IT" sz="1400" b="0" i="0" dirty="0" err="1" smtClean="0">
                <a:solidFill>
                  <a:srgbClr val="040503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it-IT" sz="1400" b="0" i="0" dirty="0" smtClean="0">
                <a:solidFill>
                  <a:srgbClr val="040503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it-IT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it-IT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3" name="Immagine 9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428076" y="-18763"/>
            <a:ext cx="2871019" cy="1838360"/>
          </a:xfrm>
          <a:prstGeom prst="rect">
            <a:avLst/>
          </a:prstGeom>
          <a:ln>
            <a:noFill/>
          </a:ln>
        </p:spPr>
      </p:pic>
      <p:pic>
        <p:nvPicPr>
          <p:cNvPr id="94" name="Immagine 93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442978" y="1604728"/>
            <a:ext cx="2476658" cy="1585844"/>
          </a:xfrm>
          <a:prstGeom prst="rect">
            <a:avLst/>
          </a:prstGeom>
          <a:ln>
            <a:noFill/>
          </a:ln>
        </p:spPr>
      </p:pic>
      <p:sp>
        <p:nvSpPr>
          <p:cNvPr id="95" name="Rettangolo 94"/>
          <p:cNvSpPr/>
          <p:nvPr/>
        </p:nvSpPr>
        <p:spPr>
          <a:xfrm>
            <a:off x="1495105" y="647220"/>
            <a:ext cx="9348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>
                <a:solidFill>
                  <a:srgbClr val="04050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X-4 </a:t>
            </a:r>
            <a:endParaRPr lang="it-IT" dirty="0"/>
          </a:p>
        </p:txBody>
      </p:sp>
      <p:sp>
        <p:nvSpPr>
          <p:cNvPr id="96" name="Rettangolo 95"/>
          <p:cNvSpPr/>
          <p:nvPr/>
        </p:nvSpPr>
        <p:spPr>
          <a:xfrm>
            <a:off x="1547259" y="2299647"/>
            <a:ext cx="88517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it-IT" dirty="0"/>
          </a:p>
        </p:txBody>
      </p:sp>
      <p:pic>
        <p:nvPicPr>
          <p:cNvPr id="97" name="Immagine 96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756653" y="1344141"/>
            <a:ext cx="3840744" cy="428910"/>
          </a:xfrm>
          <a:prstGeom prst="rect">
            <a:avLst/>
          </a:prstGeom>
          <a:ln>
            <a:noFill/>
          </a:ln>
        </p:spPr>
      </p:pic>
      <p:sp>
        <p:nvSpPr>
          <p:cNvPr id="98" name="CasellaDiTesto 97"/>
          <p:cNvSpPr txBox="1"/>
          <p:nvPr/>
        </p:nvSpPr>
        <p:spPr>
          <a:xfrm>
            <a:off x="5824903" y="575918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/>
              <a:t>Lane 1</a:t>
            </a:r>
            <a:endParaRPr lang="it-IT" sz="1000" dirty="0"/>
          </a:p>
        </p:txBody>
      </p:sp>
      <p:sp>
        <p:nvSpPr>
          <p:cNvPr id="99" name="CasellaDiTesto 98"/>
          <p:cNvSpPr txBox="1"/>
          <p:nvPr/>
        </p:nvSpPr>
        <p:spPr>
          <a:xfrm>
            <a:off x="8906869" y="612889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/>
              <a:t>Lane 2</a:t>
            </a:r>
            <a:endParaRPr lang="it-IT" sz="1000" dirty="0"/>
          </a:p>
        </p:txBody>
      </p:sp>
      <p:sp>
        <p:nvSpPr>
          <p:cNvPr id="100" name="CasellaDiTesto 99"/>
          <p:cNvSpPr txBox="1"/>
          <p:nvPr/>
        </p:nvSpPr>
        <p:spPr>
          <a:xfrm>
            <a:off x="6351009" y="589845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/>
              <a:t>Lane 3</a:t>
            </a:r>
            <a:endParaRPr lang="it-IT" sz="1000" dirty="0"/>
          </a:p>
        </p:txBody>
      </p:sp>
      <p:sp>
        <p:nvSpPr>
          <p:cNvPr id="101" name="Rettangolo 100"/>
          <p:cNvSpPr/>
          <p:nvPr/>
        </p:nvSpPr>
        <p:spPr>
          <a:xfrm>
            <a:off x="5789229" y="574003"/>
            <a:ext cx="538239" cy="190264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02" name="Rettangolo 101"/>
          <p:cNvSpPr/>
          <p:nvPr/>
        </p:nvSpPr>
        <p:spPr>
          <a:xfrm>
            <a:off x="6372606" y="560739"/>
            <a:ext cx="538239" cy="190264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03" name="Rettangolo 102"/>
          <p:cNvSpPr/>
          <p:nvPr/>
        </p:nvSpPr>
        <p:spPr>
          <a:xfrm>
            <a:off x="8943439" y="574003"/>
            <a:ext cx="538239" cy="190264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078841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po 2"/>
          <p:cNvGrpSpPr/>
          <p:nvPr/>
        </p:nvGrpSpPr>
        <p:grpSpPr>
          <a:xfrm>
            <a:off x="1197821" y="-33389"/>
            <a:ext cx="8368719" cy="3590475"/>
            <a:chOff x="1115482" y="3026126"/>
            <a:chExt cx="8368719" cy="3590475"/>
          </a:xfrm>
        </p:grpSpPr>
        <p:pic>
          <p:nvPicPr>
            <p:cNvPr id="4" name="Immagine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113170" y="4496776"/>
              <a:ext cx="2847975" cy="409575"/>
            </a:xfrm>
            <a:prstGeom prst="rect">
              <a:avLst/>
            </a:prstGeom>
            <a:ln>
              <a:solidFill>
                <a:sysClr val="windowText" lastClr="000000"/>
              </a:solidFill>
            </a:ln>
          </p:spPr>
        </p:pic>
        <p:sp>
          <p:nvSpPr>
            <p:cNvPr id="6" name="Rettangolo 5"/>
            <p:cNvSpPr/>
            <p:nvPr/>
          </p:nvSpPr>
          <p:spPr>
            <a:xfrm>
              <a:off x="8112600" y="4557936"/>
              <a:ext cx="1371601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it-IT" sz="1400" dirty="0" err="1">
                  <a:solidFill>
                    <a:srgbClr val="04050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ERK</a:t>
              </a:r>
              <a:r>
                <a:rPr lang="it-IT" sz="1400" dirty="0">
                  <a:solidFill>
                    <a:srgbClr val="04050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(42 </a:t>
              </a:r>
              <a:r>
                <a:rPr lang="it-IT" sz="1400" dirty="0" err="1">
                  <a:solidFill>
                    <a:srgbClr val="04050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r>
                <a:rPr lang="it-IT" sz="1400" dirty="0">
                  <a:solidFill>
                    <a:srgbClr val="04050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r>
                <a:rPr lang="it-IT" sz="14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</p:txBody>
        </p:sp>
        <p:sp>
          <p:nvSpPr>
            <p:cNvPr id="7" name="CasellaDiTesto 6"/>
            <p:cNvSpPr txBox="1"/>
            <p:nvPr/>
          </p:nvSpPr>
          <p:spPr>
            <a:xfrm>
              <a:off x="8187353" y="5098415"/>
              <a:ext cx="1272784" cy="215444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l-GR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β</a:t>
              </a:r>
              <a:r>
                <a:rPr kumimoji="0" lang="it-IT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it-IT" sz="1400" b="0" i="0" u="none" strike="noStrike" kern="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actin</a:t>
              </a:r>
              <a:r>
                <a:rPr kumimoji="0" lang="it-IT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it-IT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srgbClr val="040503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(42 </a:t>
              </a:r>
              <a:r>
                <a:rPr kumimoji="0" lang="it-IT" sz="1400" b="0" i="0" u="none" strike="noStrike" kern="0" cap="none" spc="0" normalizeH="0" baseline="0" noProof="0" dirty="0" err="1" smtClean="0">
                  <a:ln>
                    <a:noFill/>
                  </a:ln>
                  <a:solidFill>
                    <a:srgbClr val="040503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r>
                <a:rPr kumimoji="0" lang="it-IT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srgbClr val="040503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r>
                <a:rPr kumimoji="0" lang="it-IT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kumimoji="0" lang="it-IT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Rettangolo 7"/>
            <p:cNvSpPr/>
            <p:nvPr/>
          </p:nvSpPr>
          <p:spPr>
            <a:xfrm rot="16200000">
              <a:off x="6070567" y="5621942"/>
              <a:ext cx="748251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it-IT" sz="1000" dirty="0">
                  <a:solidFill>
                    <a:srgbClr val="04050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MW-HA </a:t>
              </a:r>
            </a:p>
            <a:p>
              <a:pPr algn="ctr"/>
              <a:r>
                <a:rPr lang="it-IT" sz="1000" dirty="0">
                  <a:solidFill>
                    <a:srgbClr val="04050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hIL-17A</a:t>
              </a:r>
              <a:r>
                <a:rPr lang="it-IT" sz="1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</p:txBody>
        </p:sp>
        <p:sp>
          <p:nvSpPr>
            <p:cNvPr id="9" name="Rettangolo 8"/>
            <p:cNvSpPr/>
            <p:nvPr/>
          </p:nvSpPr>
          <p:spPr>
            <a:xfrm rot="16200000">
              <a:off x="6604112" y="5664056"/>
              <a:ext cx="832478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it-IT" sz="1000" dirty="0">
                  <a:solidFill>
                    <a:srgbClr val="04050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MW-HA </a:t>
              </a:r>
            </a:p>
            <a:p>
              <a:pPr algn="ctr"/>
              <a:r>
                <a:rPr lang="it-IT" sz="1000" dirty="0">
                  <a:solidFill>
                    <a:srgbClr val="04050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hIL-17A</a:t>
              </a:r>
              <a:r>
                <a:rPr lang="it-IT" sz="1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</p:txBody>
        </p:sp>
        <p:sp>
          <p:nvSpPr>
            <p:cNvPr id="10" name="Rettangolo 9"/>
            <p:cNvSpPr/>
            <p:nvPr/>
          </p:nvSpPr>
          <p:spPr>
            <a:xfrm rot="16200000">
              <a:off x="7231569" y="5615310"/>
              <a:ext cx="734987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it-IT" sz="1000" dirty="0">
                  <a:solidFill>
                    <a:srgbClr val="04050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MW-HA </a:t>
              </a:r>
            </a:p>
            <a:p>
              <a:pPr algn="ctr"/>
              <a:r>
                <a:rPr lang="it-IT" sz="1000" dirty="0">
                  <a:solidFill>
                    <a:srgbClr val="04050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hIL-17A</a:t>
              </a:r>
              <a:r>
                <a:rPr lang="it-IT" sz="1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</p:txBody>
        </p:sp>
        <p:sp>
          <p:nvSpPr>
            <p:cNvPr id="15" name="CasellaDiTesto 14"/>
            <p:cNvSpPr txBox="1"/>
            <p:nvPr/>
          </p:nvSpPr>
          <p:spPr>
            <a:xfrm rot="16200000">
              <a:off x="5090752" y="5664055"/>
              <a:ext cx="76853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Untreated</a:t>
              </a:r>
              <a:r>
                <a:rPr kumimoji="0" lang="it-IT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/>
              </a:r>
              <a:br>
                <a:rPr kumimoji="0" lang="it-IT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</a:br>
              <a:r>
                <a:rPr kumimoji="0" lang="it-IT" sz="10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ells</a:t>
              </a:r>
              <a:r>
                <a:rPr kumimoji="0" lang="it-IT" sz="10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 </a:t>
              </a:r>
              <a:endParaRPr kumimoji="0" lang="it-IT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Rettangolo 15"/>
            <p:cNvSpPr/>
            <p:nvPr/>
          </p:nvSpPr>
          <p:spPr>
            <a:xfrm rot="16200000">
              <a:off x="5633331" y="5701849"/>
              <a:ext cx="690237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it-IT" sz="1000" dirty="0">
                  <a:solidFill>
                    <a:srgbClr val="04050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hIL-17A</a:t>
              </a:r>
              <a:r>
                <a:rPr lang="it-IT" sz="1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</p:txBody>
        </p:sp>
        <p:pic>
          <p:nvPicPr>
            <p:cNvPr id="18" name="Immagine 17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102433" y="5012814"/>
              <a:ext cx="2858712" cy="435057"/>
            </a:xfrm>
            <a:prstGeom prst="rect">
              <a:avLst/>
            </a:prstGeom>
            <a:ln>
              <a:solidFill>
                <a:sysClr val="windowText" lastClr="000000"/>
              </a:solidFill>
            </a:ln>
          </p:spPr>
        </p:pic>
        <p:sp>
          <p:nvSpPr>
            <p:cNvPr id="19" name="Rettangolo 18"/>
            <p:cNvSpPr/>
            <p:nvPr/>
          </p:nvSpPr>
          <p:spPr>
            <a:xfrm>
              <a:off x="1240893" y="3693614"/>
              <a:ext cx="761747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800" b="0" i="0" u="none" strike="noStrike" kern="0" cap="none" spc="0" normalizeH="0" baseline="0" noProof="0" dirty="0" err="1">
                  <a:ln>
                    <a:noFill/>
                  </a:ln>
                  <a:solidFill>
                    <a:srgbClr val="040503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pERK</a:t>
              </a:r>
              <a:endParaRPr kumimoji="0" lang="it-IT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pic>
          <p:nvPicPr>
            <p:cNvPr id="20" name="Immagine 19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002640" y="3026126"/>
              <a:ext cx="1920370" cy="1854435"/>
            </a:xfrm>
            <a:prstGeom prst="rect">
              <a:avLst/>
            </a:prstGeom>
            <a:ln>
              <a:noFill/>
            </a:ln>
          </p:spPr>
        </p:pic>
        <p:pic>
          <p:nvPicPr>
            <p:cNvPr id="21" name="Immagine 20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923322" y="4611246"/>
              <a:ext cx="2317112" cy="2005355"/>
            </a:xfrm>
            <a:prstGeom prst="rect">
              <a:avLst/>
            </a:prstGeom>
            <a:ln>
              <a:noFill/>
            </a:ln>
          </p:spPr>
        </p:pic>
        <p:sp>
          <p:nvSpPr>
            <p:cNvPr id="22" name="Rettangolo 21"/>
            <p:cNvSpPr/>
            <p:nvPr/>
          </p:nvSpPr>
          <p:spPr>
            <a:xfrm>
              <a:off x="1115482" y="5514303"/>
              <a:ext cx="891591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l-GR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β</a:t>
              </a:r>
              <a:r>
                <a:rPr kumimoji="0" lang="it-IT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it-IT" sz="18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actin</a:t>
              </a:r>
              <a:r>
                <a:rPr kumimoji="0" lang="it-IT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kumimoji="0" lang="it-IT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24" name="CasellaDiTesto 23"/>
            <p:cNvSpPr txBox="1"/>
            <p:nvPr/>
          </p:nvSpPr>
          <p:spPr>
            <a:xfrm>
              <a:off x="6990140" y="3909912"/>
              <a:ext cx="108529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4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</a:t>
              </a:r>
              <a:r>
                <a:rPr lang="it-IT" sz="14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a</a:t>
              </a:r>
              <a:endParaRPr lang="it-IT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Rettangolo 24"/>
            <p:cNvSpPr/>
            <p:nvPr/>
          </p:nvSpPr>
          <p:spPr>
            <a:xfrm>
              <a:off x="5021149" y="4217690"/>
              <a:ext cx="3014750" cy="1998722"/>
            </a:xfrm>
            <a:prstGeom prst="rect">
              <a:avLst/>
            </a:prstGeom>
            <a:noFill/>
            <a:ln w="12700" cap="flat" cmpd="sng" algn="ctr">
              <a:solidFill>
                <a:srgbClr val="FF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6" name="CasellaDiTesto 25"/>
            <p:cNvSpPr txBox="1"/>
            <p:nvPr/>
          </p:nvSpPr>
          <p:spPr>
            <a:xfrm>
              <a:off x="5132540" y="4222483"/>
              <a:ext cx="5261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Lane 1</a:t>
              </a:r>
              <a:endParaRPr kumimoji="0" lang="it-IT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27" name="CasellaDiTesto 26"/>
            <p:cNvSpPr txBox="1"/>
            <p:nvPr/>
          </p:nvSpPr>
          <p:spPr>
            <a:xfrm>
              <a:off x="5724327" y="4222483"/>
              <a:ext cx="5261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Lane </a:t>
              </a:r>
              <a:r>
                <a:rPr kumimoji="0" lang="it-IT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2</a:t>
              </a:r>
            </a:p>
          </p:txBody>
        </p:sp>
        <p:sp>
          <p:nvSpPr>
            <p:cNvPr id="28" name="CasellaDiTesto 27"/>
            <p:cNvSpPr txBox="1"/>
            <p:nvPr/>
          </p:nvSpPr>
          <p:spPr>
            <a:xfrm>
              <a:off x="6288326" y="4222483"/>
              <a:ext cx="5261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Lane 3</a:t>
              </a:r>
              <a:endParaRPr kumimoji="0" lang="it-IT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29" name="CasellaDiTesto 28"/>
            <p:cNvSpPr txBox="1"/>
            <p:nvPr/>
          </p:nvSpPr>
          <p:spPr>
            <a:xfrm>
              <a:off x="7395972" y="4222483"/>
              <a:ext cx="5261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Lane 5</a:t>
              </a:r>
              <a:endParaRPr kumimoji="0" lang="it-IT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30" name="CasellaDiTesto 29"/>
            <p:cNvSpPr txBox="1"/>
            <p:nvPr/>
          </p:nvSpPr>
          <p:spPr>
            <a:xfrm>
              <a:off x="6879755" y="4222483"/>
              <a:ext cx="5261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Lane 4</a:t>
              </a:r>
              <a:endParaRPr kumimoji="0" lang="it-IT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</p:grpSp>
      <p:grpSp>
        <p:nvGrpSpPr>
          <p:cNvPr id="57" name="Gruppo 56"/>
          <p:cNvGrpSpPr/>
          <p:nvPr/>
        </p:nvGrpSpPr>
        <p:grpSpPr>
          <a:xfrm>
            <a:off x="344560" y="3557086"/>
            <a:ext cx="11186091" cy="3695611"/>
            <a:chOff x="344560" y="3557086"/>
            <a:chExt cx="11186091" cy="3695611"/>
          </a:xfrm>
        </p:grpSpPr>
        <p:grpSp>
          <p:nvGrpSpPr>
            <p:cNvPr id="31" name="Gruppo 30"/>
            <p:cNvGrpSpPr/>
            <p:nvPr/>
          </p:nvGrpSpPr>
          <p:grpSpPr>
            <a:xfrm>
              <a:off x="5155812" y="4632865"/>
              <a:ext cx="6374839" cy="1784831"/>
              <a:chOff x="5596374" y="3655710"/>
              <a:chExt cx="6374839" cy="1784831"/>
            </a:xfrm>
          </p:grpSpPr>
          <p:grpSp>
            <p:nvGrpSpPr>
              <p:cNvPr id="32" name="Gruppo 31"/>
              <p:cNvGrpSpPr/>
              <p:nvPr/>
            </p:nvGrpSpPr>
            <p:grpSpPr>
              <a:xfrm>
                <a:off x="5596374" y="3655710"/>
                <a:ext cx="6374839" cy="1784831"/>
                <a:chOff x="2576447" y="1752320"/>
                <a:chExt cx="6374839" cy="1784831"/>
              </a:xfrm>
            </p:grpSpPr>
            <p:pic>
              <p:nvPicPr>
                <p:cNvPr id="36" name="Immagine 35"/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2576447" y="2240899"/>
                  <a:ext cx="4956929" cy="427423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37" name="Rettangolo 36"/>
                <p:cNvSpPr/>
                <p:nvPr/>
              </p:nvSpPr>
              <p:spPr>
                <a:xfrm rot="16200000">
                  <a:off x="3492369" y="2878744"/>
                  <a:ext cx="748251" cy="400110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it-IT" sz="1000" b="0" i="0" dirty="0" smtClean="0">
                      <a:solidFill>
                        <a:srgbClr val="040503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MW-HA </a:t>
                  </a:r>
                </a:p>
                <a:p>
                  <a:pPr algn="ctr"/>
                  <a:r>
                    <a:rPr lang="it-IT" sz="1000" b="0" i="0" dirty="0" smtClean="0">
                      <a:solidFill>
                        <a:srgbClr val="040503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hIL-17A</a:t>
                  </a:r>
                  <a:r>
                    <a:rPr lang="it-IT" sz="10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endParaRPr lang="it-IT" sz="1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8" name="Rettangolo 37"/>
                <p:cNvSpPr/>
                <p:nvPr/>
              </p:nvSpPr>
              <p:spPr>
                <a:xfrm rot="16200000">
                  <a:off x="4025914" y="2920857"/>
                  <a:ext cx="832478" cy="400110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it-IT" sz="1000" b="0" i="0" dirty="0" smtClean="0">
                      <a:solidFill>
                        <a:srgbClr val="040503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MW-HA </a:t>
                  </a:r>
                </a:p>
                <a:p>
                  <a:pPr algn="ctr"/>
                  <a:r>
                    <a:rPr lang="it-IT" sz="1000" b="0" i="0" dirty="0" smtClean="0">
                      <a:solidFill>
                        <a:srgbClr val="040503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hIL-17A</a:t>
                  </a:r>
                  <a:r>
                    <a:rPr lang="it-IT" sz="10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endParaRPr lang="it-IT" sz="1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9" name="Rettangolo 38"/>
                <p:cNvSpPr/>
                <p:nvPr/>
              </p:nvSpPr>
              <p:spPr>
                <a:xfrm rot="16200000">
                  <a:off x="4653371" y="2872112"/>
                  <a:ext cx="734987" cy="400110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it-IT" sz="1000" b="0" i="0" dirty="0" smtClean="0">
                      <a:solidFill>
                        <a:srgbClr val="040503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LMW-HA </a:t>
                  </a:r>
                </a:p>
                <a:p>
                  <a:pPr algn="ctr"/>
                  <a:r>
                    <a:rPr lang="it-IT" sz="1000" b="0" i="0" dirty="0" smtClean="0">
                      <a:solidFill>
                        <a:srgbClr val="040503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hIL-17A</a:t>
                  </a:r>
                  <a:r>
                    <a:rPr lang="it-IT" sz="10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endParaRPr lang="it-IT" sz="1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0" name="Rettangolo 39"/>
                <p:cNvSpPr/>
                <p:nvPr/>
              </p:nvSpPr>
              <p:spPr>
                <a:xfrm rot="16200000">
                  <a:off x="5198523" y="2926682"/>
                  <a:ext cx="690237" cy="246221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r"/>
                  <a:r>
                    <a:rPr lang="it-IT" sz="1000" b="0" i="0" dirty="0" smtClean="0">
                      <a:solidFill>
                        <a:srgbClr val="040503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MA</a:t>
                  </a:r>
                  <a:endParaRPr lang="it-IT" sz="1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1" name="CasellaDiTesto 40"/>
                <p:cNvSpPr txBox="1"/>
                <p:nvPr/>
              </p:nvSpPr>
              <p:spPr>
                <a:xfrm rot="16200000">
                  <a:off x="2482661" y="2888888"/>
                  <a:ext cx="768538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it-IT" sz="1000" dirty="0" err="1"/>
                    <a:t>Untreated</a:t>
                  </a:r>
                  <a:r>
                    <a:rPr lang="it-IT" sz="1000" dirty="0"/>
                    <a:t/>
                  </a:r>
                  <a:br>
                    <a:rPr lang="it-IT" sz="1000" dirty="0"/>
                  </a:br>
                  <a:r>
                    <a:rPr lang="it-IT" sz="1000" dirty="0" err="1"/>
                    <a:t>cells</a:t>
                  </a:r>
                  <a:r>
                    <a:rPr lang="it-IT" sz="1000" dirty="0" smtClean="0"/>
                    <a:t> </a:t>
                  </a:r>
                  <a:endParaRPr lang="it-IT" sz="1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2" name="Rettangolo 41"/>
                <p:cNvSpPr/>
                <p:nvPr/>
              </p:nvSpPr>
              <p:spPr>
                <a:xfrm rot="16200000">
                  <a:off x="3028440" y="2926682"/>
                  <a:ext cx="690237" cy="246221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r"/>
                  <a:r>
                    <a:rPr lang="it-IT" sz="1000" b="0" i="0" dirty="0" smtClean="0">
                      <a:solidFill>
                        <a:srgbClr val="040503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hIL-17A</a:t>
                  </a:r>
                  <a:r>
                    <a:rPr lang="it-IT" sz="10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endParaRPr lang="it-IT" sz="1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4" name="Rettangolo 43"/>
                <p:cNvSpPr/>
                <p:nvPr/>
              </p:nvSpPr>
              <p:spPr>
                <a:xfrm>
                  <a:off x="7579892" y="1752320"/>
                  <a:ext cx="1371394" cy="307777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r">
                    <a:spcBef>
                      <a:spcPct val="0"/>
                    </a:spcBef>
                    <a:defRPr/>
                  </a:pPr>
                  <a:r>
                    <a:rPr lang="it-IT" altLang="it-IT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-</a:t>
                  </a:r>
                  <a:r>
                    <a:rPr lang="it-IT" altLang="it-IT" sz="140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kba</a:t>
                  </a:r>
                  <a:r>
                    <a:rPr lang="it-IT" altLang="it-IT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(40 </a:t>
                  </a:r>
                  <a:r>
                    <a:rPr lang="it-IT" altLang="it-IT" sz="140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r>
                    <a:rPr lang="it-IT" altLang="it-IT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)</a:t>
                  </a:r>
                </a:p>
              </p:txBody>
            </p:sp>
            <p:sp>
              <p:nvSpPr>
                <p:cNvPr id="45" name="CasellaDiTesto 44"/>
                <p:cNvSpPr txBox="1"/>
                <p:nvPr/>
              </p:nvSpPr>
              <p:spPr>
                <a:xfrm>
                  <a:off x="7664116" y="2363303"/>
                  <a:ext cx="1272784" cy="215444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r>
                    <a:rPr lang="el-GR" sz="1400" dirty="0" smtClean="0"/>
                    <a:t>β</a:t>
                  </a:r>
                  <a:r>
                    <a:rPr lang="it-IT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</a:t>
                  </a:r>
                  <a:r>
                    <a:rPr lang="it-IT" sz="14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ctin</a:t>
                  </a:r>
                  <a:r>
                    <a:rPr lang="it-IT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lang="it-IT" sz="1400" b="0" i="0" dirty="0" smtClean="0">
                      <a:solidFill>
                        <a:srgbClr val="040503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(42 </a:t>
                  </a:r>
                  <a:r>
                    <a:rPr lang="it-IT" sz="1400" b="0" i="0" dirty="0" err="1" smtClean="0">
                      <a:solidFill>
                        <a:srgbClr val="040503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r>
                    <a:rPr lang="it-IT" sz="1400" b="0" i="0" dirty="0" smtClean="0">
                      <a:solidFill>
                        <a:srgbClr val="040503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)</a:t>
                  </a:r>
                  <a:r>
                    <a:rPr lang="it-IT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endParaRPr lang="it-IT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33" name="Rettangolo 32"/>
              <p:cNvSpPr/>
              <p:nvPr/>
            </p:nvSpPr>
            <p:spPr>
              <a:xfrm rot="16200000">
                <a:off x="8808160" y="4749123"/>
                <a:ext cx="692519" cy="40011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it-IT" sz="1000" b="0" i="0" dirty="0" smtClean="0">
                    <a:solidFill>
                      <a:srgbClr val="040503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0126</a:t>
                </a:r>
              </a:p>
              <a:p>
                <a:pPr algn="ctr"/>
                <a:r>
                  <a:rPr lang="it-IT" sz="1000" b="0" i="0" dirty="0" smtClean="0">
                    <a:solidFill>
                      <a:srgbClr val="040503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hIL-17A</a:t>
                </a:r>
                <a:r>
                  <a:rPr lang="it-IT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it-IT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Rettangolo 33"/>
              <p:cNvSpPr/>
              <p:nvPr/>
            </p:nvSpPr>
            <p:spPr>
              <a:xfrm rot="16200000">
                <a:off x="9359497" y="4793152"/>
                <a:ext cx="692519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it-IT" sz="1000" b="0" i="0" dirty="0" smtClean="0">
                    <a:solidFill>
                      <a:srgbClr val="040503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hIL-17A</a:t>
                </a:r>
                <a:r>
                  <a:rPr lang="it-IT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it-IT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CasellaDiTesto 34"/>
              <p:cNvSpPr txBox="1"/>
              <p:nvPr/>
            </p:nvSpPr>
            <p:spPr>
              <a:xfrm rot="16200000">
                <a:off x="9905424" y="4749123"/>
                <a:ext cx="768538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dirty="0" err="1"/>
                  <a:t>Untreated</a:t>
                </a:r>
                <a:r>
                  <a:rPr lang="it-IT" sz="1000" dirty="0"/>
                  <a:t/>
                </a:r>
                <a:br>
                  <a:rPr lang="it-IT" sz="1000" dirty="0"/>
                </a:br>
                <a:r>
                  <a:rPr lang="it-IT" sz="1000" dirty="0" err="1"/>
                  <a:t>cells</a:t>
                </a:r>
                <a:r>
                  <a:rPr lang="it-IT" sz="1000" dirty="0" smtClean="0"/>
                  <a:t> </a:t>
                </a:r>
                <a:endParaRPr lang="it-IT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46" name="Immagine 45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954384" y="5316522"/>
              <a:ext cx="2883369" cy="1936175"/>
            </a:xfrm>
            <a:prstGeom prst="rect">
              <a:avLst/>
            </a:prstGeom>
            <a:ln>
              <a:noFill/>
            </a:ln>
          </p:spPr>
        </p:pic>
        <p:sp>
          <p:nvSpPr>
            <p:cNvPr id="47" name="Rettangolo 46"/>
            <p:cNvSpPr/>
            <p:nvPr/>
          </p:nvSpPr>
          <p:spPr>
            <a:xfrm>
              <a:off x="344560" y="4009799"/>
              <a:ext cx="1480593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>
                <a:spcBef>
                  <a:spcPct val="0"/>
                </a:spcBef>
                <a:defRPr/>
              </a:pPr>
              <a:r>
                <a:rPr lang="it-IT" altLang="it-IT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-</a:t>
              </a:r>
              <a:r>
                <a:rPr lang="it-IT" altLang="it-IT" sz="14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kba</a:t>
              </a:r>
              <a:endParaRPr lang="it-IT" altLang="it-IT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CasellaDiTesto 47"/>
            <p:cNvSpPr txBox="1"/>
            <p:nvPr/>
          </p:nvSpPr>
          <p:spPr>
            <a:xfrm>
              <a:off x="1000313" y="6136475"/>
              <a:ext cx="504946" cy="215444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l-GR" sz="1400" dirty="0" smtClean="0"/>
                <a:t>β</a:t>
              </a:r>
              <a:r>
                <a:rPr lang="it-IT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lang="it-IT" sz="14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tin</a:t>
              </a:r>
              <a:endParaRPr lang="it-IT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49" name="Immagine 48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5130194" y="4535466"/>
              <a:ext cx="4945359" cy="463773"/>
            </a:xfrm>
            <a:prstGeom prst="rect">
              <a:avLst/>
            </a:prstGeom>
          </p:spPr>
        </p:pic>
        <p:pic>
          <p:nvPicPr>
            <p:cNvPr id="50" name="Immagine 49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1998114" y="3557086"/>
              <a:ext cx="2839639" cy="1686809"/>
            </a:xfrm>
            <a:prstGeom prst="rect">
              <a:avLst/>
            </a:prstGeom>
          </p:spPr>
        </p:pic>
        <p:sp>
          <p:nvSpPr>
            <p:cNvPr id="51" name="Rettangolo 50"/>
            <p:cNvSpPr/>
            <p:nvPr/>
          </p:nvSpPr>
          <p:spPr>
            <a:xfrm>
              <a:off x="5053604" y="4317576"/>
              <a:ext cx="2874687" cy="199872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2" name="CasellaDiTesto 51"/>
            <p:cNvSpPr txBox="1"/>
            <p:nvPr/>
          </p:nvSpPr>
          <p:spPr>
            <a:xfrm>
              <a:off x="5106988" y="4322369"/>
              <a:ext cx="5596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/>
                <a:t>Lane 1</a:t>
              </a:r>
              <a:endParaRPr lang="it-IT" sz="1000" dirty="0"/>
            </a:p>
          </p:txBody>
        </p:sp>
        <p:sp>
          <p:nvSpPr>
            <p:cNvPr id="53" name="CasellaDiTesto 52"/>
            <p:cNvSpPr txBox="1"/>
            <p:nvPr/>
          </p:nvSpPr>
          <p:spPr>
            <a:xfrm>
              <a:off x="5720043" y="4322369"/>
              <a:ext cx="5384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/>
                <a:t>Lane </a:t>
              </a:r>
              <a:r>
                <a:rPr lang="it-IT" sz="1000" dirty="0"/>
                <a:t>2</a:t>
              </a:r>
            </a:p>
          </p:txBody>
        </p:sp>
        <p:sp>
          <p:nvSpPr>
            <p:cNvPr id="54" name="CasellaDiTesto 53"/>
            <p:cNvSpPr txBox="1"/>
            <p:nvPr/>
          </p:nvSpPr>
          <p:spPr>
            <a:xfrm>
              <a:off x="6281652" y="4322369"/>
              <a:ext cx="5407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/>
                <a:t>Lane 3</a:t>
              </a:r>
              <a:endParaRPr lang="it-IT" sz="1000" dirty="0"/>
            </a:p>
          </p:txBody>
        </p:sp>
        <p:sp>
          <p:nvSpPr>
            <p:cNvPr id="55" name="CasellaDiTesto 54"/>
            <p:cNvSpPr txBox="1"/>
            <p:nvPr/>
          </p:nvSpPr>
          <p:spPr>
            <a:xfrm>
              <a:off x="7400174" y="4322369"/>
              <a:ext cx="5299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/>
                <a:t>Lane 5</a:t>
              </a:r>
              <a:endParaRPr lang="it-IT" sz="1000" dirty="0"/>
            </a:p>
          </p:txBody>
        </p:sp>
        <p:sp>
          <p:nvSpPr>
            <p:cNvPr id="56" name="CasellaDiTesto 55"/>
            <p:cNvSpPr txBox="1"/>
            <p:nvPr/>
          </p:nvSpPr>
          <p:spPr>
            <a:xfrm>
              <a:off x="6864428" y="4322369"/>
              <a:ext cx="5494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/>
                <a:t>Lane 4</a:t>
              </a:r>
              <a:endParaRPr lang="it-IT" sz="1000" dirty="0"/>
            </a:p>
          </p:txBody>
        </p:sp>
      </p:grpSp>
    </p:spTree>
    <p:extLst>
      <p:ext uri="{BB962C8B-B14F-4D97-AF65-F5344CB8AC3E}">
        <p14:creationId xmlns:p14="http://schemas.microsoft.com/office/powerpoint/2010/main" val="5394515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/>
          <p:cNvSpPr txBox="1"/>
          <p:nvPr/>
        </p:nvSpPr>
        <p:spPr>
          <a:xfrm>
            <a:off x="6775037" y="615435"/>
            <a:ext cx="10584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Figure 4b</a:t>
            </a:r>
            <a:endParaRPr lang="it-IT" dirty="0"/>
          </a:p>
        </p:txBody>
      </p:sp>
      <p:sp>
        <p:nvSpPr>
          <p:cNvPr id="14" name="CasellaDiTesto 13"/>
          <p:cNvSpPr txBox="1"/>
          <p:nvPr/>
        </p:nvSpPr>
        <p:spPr>
          <a:xfrm>
            <a:off x="1420994" y="4018825"/>
            <a:ext cx="5020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L-8</a:t>
            </a:r>
            <a:endParaRPr lang="it-IT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ettangolo 14"/>
          <p:cNvSpPr/>
          <p:nvPr/>
        </p:nvSpPr>
        <p:spPr>
          <a:xfrm>
            <a:off x="3801798" y="4063145"/>
            <a:ext cx="73449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sz="1400" dirty="0"/>
              <a:t>β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it-IT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it-IT" sz="1400" dirty="0"/>
          </a:p>
        </p:txBody>
      </p:sp>
      <p:pic>
        <p:nvPicPr>
          <p:cNvPr id="16" name="Immagine 1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0299" y="4401479"/>
            <a:ext cx="1991803" cy="2168725"/>
          </a:xfrm>
          <a:prstGeom prst="rect">
            <a:avLst/>
          </a:prstGeom>
        </p:spPr>
      </p:pic>
      <p:pic>
        <p:nvPicPr>
          <p:cNvPr id="17" name="Immagine 1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80518" y="4436213"/>
            <a:ext cx="1828049" cy="1566151"/>
          </a:xfrm>
          <a:prstGeom prst="rect">
            <a:avLst/>
          </a:prstGeom>
        </p:spPr>
      </p:pic>
      <p:grpSp>
        <p:nvGrpSpPr>
          <p:cNvPr id="18" name="Gruppo 17"/>
          <p:cNvGrpSpPr/>
          <p:nvPr/>
        </p:nvGrpSpPr>
        <p:grpSpPr>
          <a:xfrm>
            <a:off x="5885469" y="1391300"/>
            <a:ext cx="4620613" cy="1802841"/>
            <a:chOff x="4350312" y="3378533"/>
            <a:chExt cx="4620613" cy="1802841"/>
          </a:xfrm>
        </p:grpSpPr>
        <p:pic>
          <p:nvPicPr>
            <p:cNvPr id="19" name="Immagine 18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363987" y="3378533"/>
              <a:ext cx="3092323" cy="434947"/>
            </a:xfrm>
            <a:prstGeom prst="rect">
              <a:avLst/>
            </a:prstGeom>
            <a:ln>
              <a:noFill/>
            </a:ln>
          </p:spPr>
        </p:pic>
        <p:pic>
          <p:nvPicPr>
            <p:cNvPr id="20" name="Immagine 19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350312" y="3890669"/>
              <a:ext cx="3103719" cy="432844"/>
            </a:xfrm>
            <a:prstGeom prst="rect">
              <a:avLst/>
            </a:prstGeom>
            <a:ln>
              <a:noFill/>
            </a:ln>
          </p:spPr>
        </p:pic>
        <p:sp>
          <p:nvSpPr>
            <p:cNvPr id="21" name="CasellaDiTesto 20"/>
            <p:cNvSpPr txBox="1"/>
            <p:nvPr/>
          </p:nvSpPr>
          <p:spPr>
            <a:xfrm rot="16200000">
              <a:off x="4269357" y="4533110"/>
              <a:ext cx="76853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dirty="0" err="1"/>
                <a:t>Untreated</a:t>
              </a:r>
              <a:r>
                <a:rPr lang="it-IT" sz="1000" dirty="0"/>
                <a:t/>
              </a:r>
              <a:br>
                <a:rPr lang="it-IT" sz="1000" dirty="0"/>
              </a:br>
              <a:r>
                <a:rPr lang="it-IT" sz="1000" dirty="0" err="1"/>
                <a:t>cells</a:t>
              </a:r>
              <a:r>
                <a:rPr lang="it-IT" sz="1000" dirty="0" smtClean="0"/>
                <a:t> </a:t>
              </a:r>
              <a:endParaRPr lang="it-IT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Rettangolo 21"/>
            <p:cNvSpPr/>
            <p:nvPr/>
          </p:nvSpPr>
          <p:spPr>
            <a:xfrm rot="16200000">
              <a:off x="4829937" y="4583071"/>
              <a:ext cx="690237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it-IT" sz="1000" b="0" i="0" dirty="0" smtClean="0">
                  <a:solidFill>
                    <a:srgbClr val="04050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hIL-17A</a:t>
              </a:r>
              <a:r>
                <a:rPr lang="it-IT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it-IT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Rettangolo 22"/>
            <p:cNvSpPr/>
            <p:nvPr/>
          </p:nvSpPr>
          <p:spPr>
            <a:xfrm rot="16200000">
              <a:off x="5279411" y="4523101"/>
              <a:ext cx="748251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it-IT" sz="1000" b="0" i="0" dirty="0" smtClean="0">
                  <a:solidFill>
                    <a:srgbClr val="04050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MW-HA </a:t>
              </a:r>
            </a:p>
            <a:p>
              <a:r>
                <a:rPr lang="it-IT" sz="1000" b="0" i="0" dirty="0" smtClean="0">
                  <a:solidFill>
                    <a:srgbClr val="04050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hIL-17A</a:t>
              </a:r>
              <a:r>
                <a:rPr lang="it-IT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it-IT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Rettangolo 23"/>
            <p:cNvSpPr/>
            <p:nvPr/>
          </p:nvSpPr>
          <p:spPr>
            <a:xfrm rot="16200000">
              <a:off x="5772687" y="4565080"/>
              <a:ext cx="832478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it-IT" sz="1000" b="0" i="0" dirty="0" smtClean="0">
                  <a:solidFill>
                    <a:srgbClr val="04050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MW-HA </a:t>
              </a:r>
            </a:p>
            <a:p>
              <a:pPr algn="ctr"/>
              <a:r>
                <a:rPr lang="it-IT" sz="1000" b="0" i="0" dirty="0" smtClean="0">
                  <a:solidFill>
                    <a:srgbClr val="04050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hIL-17A</a:t>
              </a:r>
              <a:r>
                <a:rPr lang="it-IT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it-IT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Rettangolo 24"/>
            <p:cNvSpPr/>
            <p:nvPr/>
          </p:nvSpPr>
          <p:spPr>
            <a:xfrm rot="16200000">
              <a:off x="6319562" y="4516335"/>
              <a:ext cx="734987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it-IT" sz="1000" b="0" i="0" dirty="0" smtClean="0">
                  <a:solidFill>
                    <a:srgbClr val="04050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MW-HA </a:t>
              </a:r>
            </a:p>
            <a:p>
              <a:r>
                <a:rPr lang="it-IT" sz="1000" b="0" i="0" dirty="0" smtClean="0">
                  <a:solidFill>
                    <a:srgbClr val="04050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hIL-17A</a:t>
              </a:r>
              <a:r>
                <a:rPr lang="it-IT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it-IT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Rettangolo 25"/>
            <p:cNvSpPr/>
            <p:nvPr/>
          </p:nvSpPr>
          <p:spPr>
            <a:xfrm rot="16200000">
              <a:off x="6864112" y="4492270"/>
              <a:ext cx="692519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it-IT" sz="1000" b="0" i="0" dirty="0" smtClean="0">
                  <a:solidFill>
                    <a:srgbClr val="04050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U0126</a:t>
              </a:r>
            </a:p>
            <a:p>
              <a:pPr algn="ctr"/>
              <a:r>
                <a:rPr lang="it-IT" sz="1000" b="0" i="0" dirty="0" smtClean="0">
                  <a:solidFill>
                    <a:srgbClr val="04050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hIL-17A</a:t>
              </a:r>
              <a:r>
                <a:rPr lang="it-IT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it-IT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Rettangolo 26"/>
            <p:cNvSpPr/>
            <p:nvPr/>
          </p:nvSpPr>
          <p:spPr>
            <a:xfrm>
              <a:off x="7514221" y="3434398"/>
              <a:ext cx="1456704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it-IT" sz="1400" b="0" i="0" dirty="0" smtClean="0">
                  <a:solidFill>
                    <a:srgbClr val="04050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OX-4 (70 </a:t>
              </a:r>
              <a:r>
                <a:rPr lang="it-IT" sz="1400" b="0" i="0" dirty="0" err="1" smtClean="0">
                  <a:solidFill>
                    <a:srgbClr val="04050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r>
                <a:rPr lang="it-IT" sz="1400" b="0" i="0" dirty="0" smtClean="0">
                  <a:solidFill>
                    <a:srgbClr val="04050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r>
                <a:rPr lang="it-IT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it-IT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CasellaDiTesto 27"/>
            <p:cNvSpPr txBox="1"/>
            <p:nvPr/>
          </p:nvSpPr>
          <p:spPr>
            <a:xfrm>
              <a:off x="7594206" y="4007748"/>
              <a:ext cx="1272784" cy="215444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l-GR" sz="1400" dirty="0" smtClean="0"/>
                <a:t>β</a:t>
              </a:r>
              <a:r>
                <a:rPr lang="it-IT" sz="1400" dirty="0" smtClean="0"/>
                <a:t>-</a:t>
              </a:r>
              <a:r>
                <a:rPr lang="it-IT" sz="1400" dirty="0" err="1" smtClean="0"/>
                <a:t>actin</a:t>
              </a:r>
              <a:r>
                <a:rPr lang="it-IT" sz="1400" dirty="0" smtClean="0"/>
                <a:t> </a:t>
              </a:r>
              <a:r>
                <a:rPr lang="it-IT" sz="1400" b="0" i="0" dirty="0" smtClean="0">
                  <a:solidFill>
                    <a:srgbClr val="04050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42 </a:t>
              </a:r>
              <a:r>
                <a:rPr lang="it-IT" sz="1400" b="0" i="0" dirty="0" err="1" smtClean="0">
                  <a:solidFill>
                    <a:srgbClr val="04050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r>
                <a:rPr lang="it-IT" sz="1400" b="0" i="0" dirty="0" smtClean="0">
                  <a:solidFill>
                    <a:srgbClr val="04050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r>
                <a:rPr lang="it-IT" sz="1400" dirty="0" smtClean="0"/>
                <a:t> </a:t>
              </a:r>
              <a:endParaRPr lang="it-IT" sz="1400" dirty="0"/>
            </a:p>
          </p:txBody>
        </p:sp>
      </p:grpSp>
      <p:pic>
        <p:nvPicPr>
          <p:cNvPr id="29" name="Immagine 2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36925" y="2324099"/>
            <a:ext cx="3408992" cy="1493365"/>
          </a:xfrm>
          <a:prstGeom prst="rect">
            <a:avLst/>
          </a:prstGeom>
          <a:ln>
            <a:noFill/>
          </a:ln>
        </p:spPr>
      </p:pic>
      <p:sp>
        <p:nvSpPr>
          <p:cNvPr id="30" name="Rettangolo 29"/>
          <p:cNvSpPr/>
          <p:nvPr/>
        </p:nvSpPr>
        <p:spPr>
          <a:xfrm>
            <a:off x="3842296" y="1128916"/>
            <a:ext cx="9348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>
                <a:solidFill>
                  <a:srgbClr val="04050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X-4 </a:t>
            </a:r>
            <a:endParaRPr lang="it-IT" dirty="0"/>
          </a:p>
        </p:txBody>
      </p:sp>
      <p:sp>
        <p:nvSpPr>
          <p:cNvPr id="31" name="Rettangolo 30"/>
          <p:cNvSpPr/>
          <p:nvPr/>
        </p:nvSpPr>
        <p:spPr>
          <a:xfrm>
            <a:off x="3894450" y="2781343"/>
            <a:ext cx="88517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it-IT" dirty="0"/>
          </a:p>
        </p:txBody>
      </p:sp>
      <p:pic>
        <p:nvPicPr>
          <p:cNvPr id="32" name="Immagine 3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17718" y="553563"/>
            <a:ext cx="2591476" cy="1770536"/>
          </a:xfrm>
          <a:prstGeom prst="rect">
            <a:avLst/>
          </a:prstGeom>
        </p:spPr>
      </p:pic>
      <p:sp>
        <p:nvSpPr>
          <p:cNvPr id="33" name="Rettangolo 32"/>
          <p:cNvSpPr/>
          <p:nvPr/>
        </p:nvSpPr>
        <p:spPr>
          <a:xfrm>
            <a:off x="5789229" y="1133310"/>
            <a:ext cx="2741493" cy="19987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4" name="CasellaDiTesto 33"/>
          <p:cNvSpPr txBox="1"/>
          <p:nvPr/>
        </p:nvSpPr>
        <p:spPr>
          <a:xfrm>
            <a:off x="5913815" y="1138103"/>
            <a:ext cx="5596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/>
              <a:t>Lane 1</a:t>
            </a:r>
            <a:endParaRPr lang="it-IT" sz="1000" dirty="0"/>
          </a:p>
        </p:txBody>
      </p:sp>
      <p:sp>
        <p:nvSpPr>
          <p:cNvPr id="35" name="CasellaDiTesto 34"/>
          <p:cNvSpPr txBox="1"/>
          <p:nvPr/>
        </p:nvSpPr>
        <p:spPr>
          <a:xfrm>
            <a:off x="6440809" y="1138103"/>
            <a:ext cx="5384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/>
              <a:t>Lane </a:t>
            </a:r>
            <a:r>
              <a:rPr lang="it-IT" sz="1000" dirty="0"/>
              <a:t>2</a:t>
            </a:r>
          </a:p>
        </p:txBody>
      </p:sp>
      <p:sp>
        <p:nvSpPr>
          <p:cNvPr id="36" name="CasellaDiTesto 35"/>
          <p:cNvSpPr txBox="1"/>
          <p:nvPr/>
        </p:nvSpPr>
        <p:spPr>
          <a:xfrm>
            <a:off x="6927115" y="1138103"/>
            <a:ext cx="5407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/>
              <a:t>Lane 3</a:t>
            </a:r>
            <a:endParaRPr lang="it-IT" sz="1000" dirty="0"/>
          </a:p>
        </p:txBody>
      </p:sp>
      <p:sp>
        <p:nvSpPr>
          <p:cNvPr id="37" name="CasellaDiTesto 36"/>
          <p:cNvSpPr txBox="1"/>
          <p:nvPr/>
        </p:nvSpPr>
        <p:spPr>
          <a:xfrm>
            <a:off x="8002605" y="1138103"/>
            <a:ext cx="5299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/>
              <a:t>Lane 5</a:t>
            </a:r>
            <a:endParaRPr lang="it-IT" sz="1000" dirty="0"/>
          </a:p>
        </p:txBody>
      </p:sp>
      <p:sp>
        <p:nvSpPr>
          <p:cNvPr id="38" name="CasellaDiTesto 37"/>
          <p:cNvSpPr txBox="1"/>
          <p:nvPr/>
        </p:nvSpPr>
        <p:spPr>
          <a:xfrm>
            <a:off x="7466859" y="1138103"/>
            <a:ext cx="5494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/>
              <a:t>Lane 4</a:t>
            </a:r>
            <a:endParaRPr lang="it-IT" sz="1000" dirty="0"/>
          </a:p>
        </p:txBody>
      </p:sp>
      <p:grpSp>
        <p:nvGrpSpPr>
          <p:cNvPr id="68" name="Gruppo 67"/>
          <p:cNvGrpSpPr/>
          <p:nvPr/>
        </p:nvGrpSpPr>
        <p:grpSpPr>
          <a:xfrm>
            <a:off x="5988728" y="4114550"/>
            <a:ext cx="4614009" cy="2105114"/>
            <a:chOff x="6290739" y="423313"/>
            <a:chExt cx="4614009" cy="2105114"/>
          </a:xfrm>
        </p:grpSpPr>
        <p:grpSp>
          <p:nvGrpSpPr>
            <p:cNvPr id="69" name="Gruppo 68"/>
            <p:cNvGrpSpPr/>
            <p:nvPr/>
          </p:nvGrpSpPr>
          <p:grpSpPr>
            <a:xfrm>
              <a:off x="6415435" y="766901"/>
              <a:ext cx="4489313" cy="1761526"/>
              <a:chOff x="4302018" y="669351"/>
              <a:chExt cx="4489313" cy="1761526"/>
            </a:xfrm>
          </p:grpSpPr>
          <p:pic>
            <p:nvPicPr>
              <p:cNvPr id="78" name="Immagine 77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4302018" y="669351"/>
                <a:ext cx="3135313" cy="438638"/>
              </a:xfrm>
              <a:prstGeom prst="rect">
                <a:avLst/>
              </a:prstGeom>
              <a:ln>
                <a:noFill/>
              </a:ln>
            </p:spPr>
          </p:pic>
          <p:sp>
            <p:nvSpPr>
              <p:cNvPr id="79" name="CasellaDiTesto 78"/>
              <p:cNvSpPr txBox="1"/>
              <p:nvPr/>
            </p:nvSpPr>
            <p:spPr>
              <a:xfrm rot="16200000">
                <a:off x="4248134" y="1782613"/>
                <a:ext cx="768538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dirty="0" err="1"/>
                  <a:t>Untreated</a:t>
                </a:r>
                <a:r>
                  <a:rPr lang="it-IT" sz="1000" dirty="0"/>
                  <a:t/>
                </a:r>
                <a:br>
                  <a:rPr lang="it-IT" sz="1000" dirty="0"/>
                </a:br>
                <a:r>
                  <a:rPr lang="it-IT" sz="1000" dirty="0" err="1"/>
                  <a:t>cells</a:t>
                </a:r>
                <a:r>
                  <a:rPr lang="it-IT" sz="1000" dirty="0" smtClean="0"/>
                  <a:t> </a:t>
                </a:r>
                <a:endParaRPr lang="it-IT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0" name="Rettangolo 79"/>
              <p:cNvSpPr/>
              <p:nvPr/>
            </p:nvSpPr>
            <p:spPr>
              <a:xfrm rot="16200000">
                <a:off x="4808714" y="1832574"/>
                <a:ext cx="690237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it-IT" sz="1000" b="0" i="0" dirty="0" smtClean="0">
                    <a:solidFill>
                      <a:srgbClr val="040503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hIL-17A</a:t>
                </a:r>
                <a:r>
                  <a:rPr lang="it-IT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it-IT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" name="Rettangolo 80"/>
              <p:cNvSpPr/>
              <p:nvPr/>
            </p:nvSpPr>
            <p:spPr>
              <a:xfrm rot="16200000">
                <a:off x="5258188" y="1772604"/>
                <a:ext cx="748251" cy="40011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it-IT" sz="1000" b="0" i="0" dirty="0" smtClean="0">
                    <a:solidFill>
                      <a:srgbClr val="040503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MW-HA </a:t>
                </a:r>
              </a:p>
              <a:p>
                <a:r>
                  <a:rPr lang="it-IT" sz="1000" b="0" i="0" dirty="0" smtClean="0">
                    <a:solidFill>
                      <a:srgbClr val="040503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hIL-17A</a:t>
                </a:r>
                <a:r>
                  <a:rPr lang="it-IT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it-IT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2" name="Rettangolo 81"/>
              <p:cNvSpPr/>
              <p:nvPr/>
            </p:nvSpPr>
            <p:spPr>
              <a:xfrm rot="16200000">
                <a:off x="5751464" y="1814583"/>
                <a:ext cx="832478" cy="40011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it-IT" sz="1000" b="0" i="0" dirty="0" smtClean="0">
                    <a:solidFill>
                      <a:srgbClr val="040503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W-HA </a:t>
                </a:r>
              </a:p>
              <a:p>
                <a:pPr algn="ctr"/>
                <a:r>
                  <a:rPr lang="it-IT" sz="1000" b="0" i="0" dirty="0" smtClean="0">
                    <a:solidFill>
                      <a:srgbClr val="040503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hIL-17A</a:t>
                </a:r>
                <a:r>
                  <a:rPr lang="it-IT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it-IT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3" name="Rettangolo 82"/>
              <p:cNvSpPr/>
              <p:nvPr/>
            </p:nvSpPr>
            <p:spPr>
              <a:xfrm rot="16200000">
                <a:off x="6298339" y="1765838"/>
                <a:ext cx="734987" cy="40011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it-IT" sz="1000" b="0" i="0" dirty="0" smtClean="0">
                    <a:solidFill>
                      <a:srgbClr val="040503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MW-HA </a:t>
                </a:r>
              </a:p>
              <a:p>
                <a:r>
                  <a:rPr lang="it-IT" sz="1000" b="0" i="0" dirty="0" smtClean="0">
                    <a:solidFill>
                      <a:srgbClr val="040503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hIL-17A</a:t>
                </a:r>
                <a:r>
                  <a:rPr lang="it-IT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it-IT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4" name="Rettangolo 83"/>
              <p:cNvSpPr/>
              <p:nvPr/>
            </p:nvSpPr>
            <p:spPr>
              <a:xfrm rot="16200000">
                <a:off x="6842889" y="1741773"/>
                <a:ext cx="692519" cy="40011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it-IT" sz="1000" b="0" i="0" dirty="0" smtClean="0">
                    <a:solidFill>
                      <a:srgbClr val="040503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0126</a:t>
                </a:r>
              </a:p>
              <a:p>
                <a:pPr algn="ctr"/>
                <a:r>
                  <a:rPr lang="it-IT" sz="1000" b="0" i="0" dirty="0" smtClean="0">
                    <a:solidFill>
                      <a:srgbClr val="040503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hIL-17A</a:t>
                </a:r>
                <a:r>
                  <a:rPr lang="it-IT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it-IT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5" name="CasellaDiTesto 84"/>
              <p:cNvSpPr txBox="1"/>
              <p:nvPr/>
            </p:nvSpPr>
            <p:spPr>
              <a:xfrm>
                <a:off x="7518547" y="1276399"/>
                <a:ext cx="1272784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l-GR" sz="1400" dirty="0" smtClean="0"/>
                  <a:t>β</a:t>
                </a:r>
                <a:r>
                  <a:rPr lang="it-IT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r>
                  <a:rPr lang="it-IT" sz="14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tin</a:t>
                </a:r>
                <a:r>
                  <a:rPr lang="it-IT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it-IT" sz="1400" b="0" i="0" dirty="0" smtClean="0">
                    <a:solidFill>
                      <a:srgbClr val="040503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42 </a:t>
                </a:r>
                <a:r>
                  <a:rPr lang="it-IT" sz="1400" b="0" i="0" dirty="0" err="1" smtClean="0">
                    <a:solidFill>
                      <a:srgbClr val="040503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r>
                  <a:rPr lang="it-IT" sz="1400" b="0" i="0" dirty="0" smtClean="0">
                    <a:solidFill>
                      <a:srgbClr val="040503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r>
                  <a:rPr lang="it-IT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it-IT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6" name="Rettangolo 85"/>
              <p:cNvSpPr/>
              <p:nvPr/>
            </p:nvSpPr>
            <p:spPr>
              <a:xfrm>
                <a:off x="7546991" y="745660"/>
                <a:ext cx="1172148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it-IT" sz="1400" b="0" i="0" dirty="0" smtClean="0">
                    <a:solidFill>
                      <a:srgbClr val="040503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L-8 (8 </a:t>
                </a:r>
                <a:r>
                  <a:rPr lang="it-IT" sz="1400" b="0" i="0" dirty="0" err="1" smtClean="0">
                    <a:solidFill>
                      <a:srgbClr val="040503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r>
                  <a:rPr lang="it-IT" sz="1400" b="0" i="0" dirty="0" smtClean="0">
                    <a:solidFill>
                      <a:srgbClr val="040503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r>
                  <a:rPr lang="it-IT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it-IT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70" name="Gruppo 69"/>
            <p:cNvGrpSpPr/>
            <p:nvPr/>
          </p:nvGrpSpPr>
          <p:grpSpPr>
            <a:xfrm>
              <a:off x="6290739" y="423313"/>
              <a:ext cx="3257710" cy="1998722"/>
              <a:chOff x="6290739" y="423313"/>
              <a:chExt cx="3257710" cy="1998722"/>
            </a:xfrm>
          </p:grpSpPr>
          <p:pic>
            <p:nvPicPr>
              <p:cNvPr id="71" name="Immagine 70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6401752" y="1200298"/>
                <a:ext cx="3146697" cy="42034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72" name="Rettangolo 71"/>
              <p:cNvSpPr/>
              <p:nvPr/>
            </p:nvSpPr>
            <p:spPr>
              <a:xfrm>
                <a:off x="6290739" y="423313"/>
                <a:ext cx="2769656" cy="1998722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73" name="CasellaDiTesto 72"/>
              <p:cNvSpPr txBox="1"/>
              <p:nvPr/>
            </p:nvSpPr>
            <p:spPr>
              <a:xfrm>
                <a:off x="6344122" y="428106"/>
                <a:ext cx="53922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dirty="0" smtClean="0"/>
                  <a:t>Lane 1</a:t>
                </a:r>
                <a:endParaRPr lang="it-IT" sz="1000" dirty="0"/>
              </a:p>
            </p:txBody>
          </p:sp>
          <p:sp>
            <p:nvSpPr>
              <p:cNvPr id="74" name="CasellaDiTesto 73"/>
              <p:cNvSpPr txBox="1"/>
              <p:nvPr/>
            </p:nvSpPr>
            <p:spPr>
              <a:xfrm>
                <a:off x="6957177" y="428106"/>
                <a:ext cx="62290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dirty="0" smtClean="0"/>
                  <a:t>Lane </a:t>
                </a:r>
                <a:r>
                  <a:rPr lang="it-IT" sz="1000" dirty="0"/>
                  <a:t>2</a:t>
                </a:r>
              </a:p>
            </p:txBody>
          </p:sp>
          <p:sp>
            <p:nvSpPr>
              <p:cNvPr id="75" name="CasellaDiTesto 74"/>
              <p:cNvSpPr txBox="1"/>
              <p:nvPr/>
            </p:nvSpPr>
            <p:spPr>
              <a:xfrm>
                <a:off x="7497271" y="428106"/>
                <a:ext cx="52103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dirty="0" smtClean="0"/>
                  <a:t>Lane 3</a:t>
                </a:r>
                <a:endParaRPr lang="it-IT" sz="1000" dirty="0"/>
              </a:p>
            </p:txBody>
          </p:sp>
          <p:sp>
            <p:nvSpPr>
              <p:cNvPr id="76" name="CasellaDiTesto 75"/>
              <p:cNvSpPr txBox="1"/>
              <p:nvPr/>
            </p:nvSpPr>
            <p:spPr>
              <a:xfrm>
                <a:off x="8535705" y="428106"/>
                <a:ext cx="55837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dirty="0" smtClean="0"/>
                  <a:t>Lane 5</a:t>
                </a:r>
                <a:endParaRPr lang="it-IT" sz="1000" dirty="0"/>
              </a:p>
            </p:txBody>
          </p:sp>
          <p:sp>
            <p:nvSpPr>
              <p:cNvPr id="77" name="CasellaDiTesto 76"/>
              <p:cNvSpPr txBox="1"/>
              <p:nvPr/>
            </p:nvSpPr>
            <p:spPr>
              <a:xfrm>
                <a:off x="8013715" y="428106"/>
                <a:ext cx="52937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dirty="0" smtClean="0"/>
                  <a:t>Lane 4</a:t>
                </a:r>
                <a:endParaRPr lang="it-IT" sz="1000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90501665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2</TotalTime>
  <Words>283</Words>
  <Application>Microsoft Office PowerPoint</Application>
  <PresentationFormat>Widescreen</PresentationFormat>
  <Paragraphs>163</Paragraphs>
  <Slides>4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tente</dc:creator>
  <cp:lastModifiedBy>utente</cp:lastModifiedBy>
  <cp:revision>8</cp:revision>
  <dcterms:created xsi:type="dcterms:W3CDTF">2019-01-10T15:51:42Z</dcterms:created>
  <dcterms:modified xsi:type="dcterms:W3CDTF">2019-01-11T13:36:08Z</dcterms:modified>
</cp:coreProperties>
</file>